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553D6D-B1FB-48CD-984F-351E54FBC1D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CEBA8B-4DE5-4F1C-90E9-87E72DC73B0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F9E3B6-917A-49B7-9C93-73E168ECDD2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0809D1-A4A3-429D-ABBC-66AEAA1BA58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49778F-4473-4815-9D63-4507AB0A29B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2B303B-98BD-44AA-8C06-A79FEB70405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2B2907-0752-43E5-A3D5-0B260B90762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E27EE0-AE97-42C1-8F05-5C671C8F0C9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1697F9-9BB0-4871-8513-F5E1AA1994E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2B0E8C-AD47-4857-83F3-1E35B0DB2CD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1218D2-8921-4103-ABCD-C2E0021F589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FBA1BA-AAFD-4838-A0BF-D93D107C4E9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A0C9EBD0-8A50-46F8-ABF2-38B78F486D39}" type="slidenum">
              <a:rPr b="0" lang="de-DE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41" name="Gerade Verbindung mit Pfeil 62"/>
          <p:cNvCxnSpPr/>
          <p:nvPr/>
        </p:nvCxnSpPr>
        <p:spPr>
          <a:xfrm flipH="1">
            <a:off x="5555520" y="4185720"/>
            <a:ext cx="376920" cy="291240"/>
          </a:xfrm>
          <a:prstGeom prst="straightConnector1">
            <a:avLst/>
          </a:prstGeom>
          <a:ln w="381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42" name="Abgerundetes Rechteck 18436"/>
          <p:cNvSpPr/>
          <p:nvPr/>
        </p:nvSpPr>
        <p:spPr>
          <a:xfrm>
            <a:off x="1114560" y="3143160"/>
            <a:ext cx="7126200" cy="3621240"/>
          </a:xfrm>
          <a:prstGeom prst="roundRect">
            <a:avLst>
              <a:gd name="adj" fmla="val 16667"/>
            </a:avLst>
          </a:prstGeom>
          <a:solidFill>
            <a:srgbClr val="f2f2f2"/>
          </a:solidFill>
          <a:ln w="57240">
            <a:solidFill>
              <a:srgbClr val="7f7f7f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3" name="Group 371" descr=""/>
          <p:cNvPicPr/>
          <p:nvPr/>
        </p:nvPicPr>
        <p:blipFill>
          <a:blip r:embed="rId1"/>
          <a:stretch/>
        </p:blipFill>
        <p:spPr>
          <a:xfrm>
            <a:off x="5327640" y="4705200"/>
            <a:ext cx="2011320" cy="1457640"/>
          </a:xfrm>
          <a:prstGeom prst="rect">
            <a:avLst/>
          </a:prstGeom>
          <a:ln w="0">
            <a:noFill/>
          </a:ln>
        </p:spPr>
      </p:pic>
      <p:grpSp>
        <p:nvGrpSpPr>
          <p:cNvPr id="44" name="Group 213"/>
          <p:cNvGrpSpPr/>
          <p:nvPr/>
        </p:nvGrpSpPr>
        <p:grpSpPr>
          <a:xfrm>
            <a:off x="5597640" y="5573880"/>
            <a:ext cx="1442880" cy="212400"/>
            <a:chOff x="5597640" y="5573880"/>
            <a:chExt cx="1442880" cy="212400"/>
          </a:xfrm>
        </p:grpSpPr>
        <p:sp>
          <p:nvSpPr>
            <p:cNvPr id="45" name="Freeform 14"/>
            <p:cNvSpPr/>
            <p:nvPr/>
          </p:nvSpPr>
          <p:spPr>
            <a:xfrm>
              <a:off x="5662800" y="5573880"/>
              <a:ext cx="42480" cy="212400"/>
            </a:xfrm>
            <a:custGeom>
              <a:avLst/>
              <a:gdLst>
                <a:gd name="textAreaLeft" fmla="*/ 0 w 42480"/>
                <a:gd name="textAreaRight" fmla="*/ 42840 w 42480"/>
                <a:gd name="textAreaTop" fmla="*/ 0 h 212400"/>
                <a:gd name="textAreaBottom" fmla="*/ 212760 h 212400"/>
              </a:gdLst>
              <a:ahLst/>
              <a:rect l="textAreaLeft" t="textAreaTop" r="textAreaRight" b="textAreaBottom"/>
              <a:pathLst>
                <a:path w="3615" h="10500">
                  <a:moveTo>
                    <a:pt x="3615" y="0"/>
                  </a:moveTo>
                  <a:cubicBezTo>
                    <a:pt x="1942" y="0"/>
                    <a:pt x="2489" y="10500"/>
                    <a:pt x="827" y="10500"/>
                  </a:cubicBezTo>
                  <a:cubicBezTo>
                    <a:pt x="0" y="10500"/>
                    <a:pt x="0" y="10500"/>
                    <a:pt x="0" y="10500"/>
                  </a:cubicBezTo>
                  <a:cubicBezTo>
                    <a:pt x="1662" y="10500"/>
                    <a:pt x="1117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" name="Freeform 10"/>
            <p:cNvSpPr/>
            <p:nvPr/>
          </p:nvSpPr>
          <p:spPr>
            <a:xfrm>
              <a:off x="5597640" y="5573880"/>
              <a:ext cx="42480" cy="212400"/>
            </a:xfrm>
            <a:custGeom>
              <a:avLst/>
              <a:gdLst>
                <a:gd name="textAreaLeft" fmla="*/ 0 w 42480"/>
                <a:gd name="textAreaRight" fmla="*/ 42840 w 42480"/>
                <a:gd name="textAreaTop" fmla="*/ 0 h 212400"/>
                <a:gd name="textAreaBottom" fmla="*/ 212760 h 212400"/>
              </a:gdLst>
              <a:ahLst/>
              <a:rect l="textAreaLeft" t="textAreaTop" r="textAreaRight" b="textAreaBottom"/>
              <a:pathLst>
                <a:path w="3615" h="10500">
                  <a:moveTo>
                    <a:pt x="3615" y="0"/>
                  </a:moveTo>
                  <a:cubicBezTo>
                    <a:pt x="1941" y="0"/>
                    <a:pt x="2489" y="10500"/>
                    <a:pt x="827" y="10500"/>
                  </a:cubicBezTo>
                  <a:cubicBezTo>
                    <a:pt x="0" y="10500"/>
                    <a:pt x="0" y="10500"/>
                    <a:pt x="0" y="10500"/>
                  </a:cubicBezTo>
                  <a:cubicBezTo>
                    <a:pt x="1662" y="10500"/>
                    <a:pt x="1117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" name="Freeform 13"/>
            <p:cNvSpPr/>
            <p:nvPr/>
          </p:nvSpPr>
          <p:spPr>
            <a:xfrm>
              <a:off x="5695920" y="5574960"/>
              <a:ext cx="42480" cy="211320"/>
            </a:xfrm>
            <a:custGeom>
              <a:avLst/>
              <a:gdLst>
                <a:gd name="textAreaLeft" fmla="*/ 0 w 42480"/>
                <a:gd name="textAreaRight" fmla="*/ 42840 w 42480"/>
                <a:gd name="textAreaTop" fmla="*/ 0 h 211320"/>
                <a:gd name="textAreaBottom" fmla="*/ 211680 h 211320"/>
              </a:gdLst>
              <a:ahLst/>
              <a:rect l="textAreaLeft" t="textAreaTop" r="textAreaRight" b="textAreaBottom"/>
              <a:pathLst>
                <a:path w="3615" h="10475">
                  <a:moveTo>
                    <a:pt x="3615" y="0"/>
                  </a:moveTo>
                  <a:cubicBezTo>
                    <a:pt x="1942" y="0"/>
                    <a:pt x="2490" y="10475"/>
                    <a:pt x="827" y="10475"/>
                  </a:cubicBezTo>
                  <a:cubicBezTo>
                    <a:pt x="0" y="10475"/>
                    <a:pt x="0" y="10475"/>
                    <a:pt x="0" y="10475"/>
                  </a:cubicBezTo>
                  <a:cubicBezTo>
                    <a:pt x="1663" y="10475"/>
                    <a:pt x="1118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" name="Freeform 9"/>
            <p:cNvSpPr/>
            <p:nvPr/>
          </p:nvSpPr>
          <p:spPr>
            <a:xfrm>
              <a:off x="5630400" y="5574960"/>
              <a:ext cx="42480" cy="211320"/>
            </a:xfrm>
            <a:custGeom>
              <a:avLst/>
              <a:gdLst>
                <a:gd name="textAreaLeft" fmla="*/ 0 w 42480"/>
                <a:gd name="textAreaRight" fmla="*/ 42840 w 42480"/>
                <a:gd name="textAreaTop" fmla="*/ 0 h 211320"/>
                <a:gd name="textAreaBottom" fmla="*/ 211680 h 211320"/>
              </a:gdLst>
              <a:ahLst/>
              <a:rect l="textAreaLeft" t="textAreaTop" r="textAreaRight" b="textAreaBottom"/>
              <a:pathLst>
                <a:path w="3615" h="10475">
                  <a:moveTo>
                    <a:pt x="3615" y="0"/>
                  </a:moveTo>
                  <a:cubicBezTo>
                    <a:pt x="1942" y="0"/>
                    <a:pt x="2489" y="10475"/>
                    <a:pt x="827" y="10475"/>
                  </a:cubicBezTo>
                  <a:cubicBezTo>
                    <a:pt x="0" y="10475"/>
                    <a:pt x="0" y="10475"/>
                    <a:pt x="0" y="10475"/>
                  </a:cubicBezTo>
                  <a:cubicBezTo>
                    <a:pt x="1662" y="10475"/>
                    <a:pt x="1118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" name="Freeform 7"/>
            <p:cNvSpPr/>
            <p:nvPr/>
          </p:nvSpPr>
          <p:spPr>
            <a:xfrm>
              <a:off x="5630400" y="5573880"/>
              <a:ext cx="42480" cy="212400"/>
            </a:xfrm>
            <a:custGeom>
              <a:avLst/>
              <a:gdLst>
                <a:gd name="textAreaLeft" fmla="*/ 0 w 42480"/>
                <a:gd name="textAreaRight" fmla="*/ 42840 w 42480"/>
                <a:gd name="textAreaTop" fmla="*/ 0 h 212400"/>
                <a:gd name="textAreaBottom" fmla="*/ 212760 h 212400"/>
              </a:gdLst>
              <a:ahLst/>
              <a:rect l="textAreaLeft" t="textAreaTop" r="textAreaRight" b="textAreaBottom"/>
              <a:pathLst>
                <a:path w="3607" h="10475">
                  <a:moveTo>
                    <a:pt x="3607" y="10475"/>
                  </a:moveTo>
                  <a:cubicBezTo>
                    <a:pt x="1937" y="10475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475"/>
                    <a:pt x="2782" y="10475"/>
                  </a:cubicBezTo>
                  <a:lnTo>
                    <a:pt x="3607" y="10475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" name="Freeform 11"/>
            <p:cNvSpPr/>
            <p:nvPr/>
          </p:nvSpPr>
          <p:spPr>
            <a:xfrm>
              <a:off x="5695920" y="5573880"/>
              <a:ext cx="42480" cy="210960"/>
            </a:xfrm>
            <a:custGeom>
              <a:avLst/>
              <a:gdLst>
                <a:gd name="textAreaLeft" fmla="*/ 0 w 42480"/>
                <a:gd name="textAreaRight" fmla="*/ 42840 w 42480"/>
                <a:gd name="textAreaTop" fmla="*/ 0 h 210960"/>
                <a:gd name="textAreaBottom" fmla="*/ 211320 h 210960"/>
              </a:gdLst>
              <a:ahLst/>
              <a:rect l="textAreaLeft" t="textAreaTop" r="textAreaRight" b="textAreaBottom"/>
              <a:pathLst>
                <a:path w="3607" h="10475">
                  <a:moveTo>
                    <a:pt x="3607" y="10475"/>
                  </a:moveTo>
                  <a:cubicBezTo>
                    <a:pt x="1937" y="10475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475"/>
                    <a:pt x="2782" y="10475"/>
                  </a:cubicBezTo>
                  <a:lnTo>
                    <a:pt x="3607" y="10475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" name="Freeform 8"/>
            <p:cNvSpPr/>
            <p:nvPr/>
          </p:nvSpPr>
          <p:spPr>
            <a:xfrm>
              <a:off x="5597640" y="5573880"/>
              <a:ext cx="42480" cy="212400"/>
            </a:xfrm>
            <a:custGeom>
              <a:avLst/>
              <a:gdLst>
                <a:gd name="textAreaLeft" fmla="*/ 0 w 42480"/>
                <a:gd name="textAreaRight" fmla="*/ 42840 w 42480"/>
                <a:gd name="textAreaTop" fmla="*/ 0 h 212400"/>
                <a:gd name="textAreaBottom" fmla="*/ 212760 h 212400"/>
              </a:gdLst>
              <a:ahLst/>
              <a:rect l="textAreaLeft" t="textAreaTop" r="textAreaRight" b="textAreaBottom"/>
              <a:pathLst>
                <a:path w="3607" h="10500">
                  <a:moveTo>
                    <a:pt x="3607" y="10500"/>
                  </a:moveTo>
                  <a:cubicBezTo>
                    <a:pt x="1937" y="10500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500"/>
                    <a:pt x="2782" y="10500"/>
                  </a:cubicBezTo>
                  <a:lnTo>
                    <a:pt x="3607" y="1050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" name="Freeform 12"/>
            <p:cNvSpPr/>
            <p:nvPr/>
          </p:nvSpPr>
          <p:spPr>
            <a:xfrm>
              <a:off x="5662800" y="5573880"/>
              <a:ext cx="42480" cy="212400"/>
            </a:xfrm>
            <a:custGeom>
              <a:avLst/>
              <a:gdLst>
                <a:gd name="textAreaLeft" fmla="*/ 0 w 42480"/>
                <a:gd name="textAreaRight" fmla="*/ 42840 w 42480"/>
                <a:gd name="textAreaTop" fmla="*/ 0 h 212400"/>
                <a:gd name="textAreaBottom" fmla="*/ 212760 h 212400"/>
              </a:gdLst>
              <a:ahLst/>
              <a:rect l="textAreaLeft" t="textAreaTop" r="textAreaRight" b="textAreaBottom"/>
              <a:pathLst>
                <a:path w="3607" h="10500">
                  <a:moveTo>
                    <a:pt x="3607" y="10500"/>
                  </a:moveTo>
                  <a:cubicBezTo>
                    <a:pt x="1937" y="10500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500"/>
                    <a:pt x="2782" y="10500"/>
                  </a:cubicBezTo>
                  <a:lnTo>
                    <a:pt x="3607" y="1050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" name="Freeform 14"/>
            <p:cNvSpPr/>
            <p:nvPr/>
          </p:nvSpPr>
          <p:spPr>
            <a:xfrm>
              <a:off x="5792040" y="5573880"/>
              <a:ext cx="42480" cy="212400"/>
            </a:xfrm>
            <a:custGeom>
              <a:avLst/>
              <a:gdLst>
                <a:gd name="textAreaLeft" fmla="*/ 0 w 42480"/>
                <a:gd name="textAreaRight" fmla="*/ 42840 w 42480"/>
                <a:gd name="textAreaTop" fmla="*/ 0 h 212400"/>
                <a:gd name="textAreaBottom" fmla="*/ 212760 h 212400"/>
              </a:gdLst>
              <a:ahLst/>
              <a:rect l="textAreaLeft" t="textAreaTop" r="textAreaRight" b="textAreaBottom"/>
              <a:pathLst>
                <a:path w="3615" h="10500">
                  <a:moveTo>
                    <a:pt x="3615" y="0"/>
                  </a:moveTo>
                  <a:cubicBezTo>
                    <a:pt x="1942" y="0"/>
                    <a:pt x="2489" y="10500"/>
                    <a:pt x="827" y="10500"/>
                  </a:cubicBezTo>
                  <a:cubicBezTo>
                    <a:pt x="0" y="10500"/>
                    <a:pt x="0" y="10500"/>
                    <a:pt x="0" y="10500"/>
                  </a:cubicBezTo>
                  <a:cubicBezTo>
                    <a:pt x="1662" y="10500"/>
                    <a:pt x="1117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" name="Freeform 10"/>
            <p:cNvSpPr/>
            <p:nvPr/>
          </p:nvSpPr>
          <p:spPr>
            <a:xfrm>
              <a:off x="5726880" y="5573880"/>
              <a:ext cx="42480" cy="212400"/>
            </a:xfrm>
            <a:custGeom>
              <a:avLst/>
              <a:gdLst>
                <a:gd name="textAreaLeft" fmla="*/ 0 w 42480"/>
                <a:gd name="textAreaRight" fmla="*/ 42840 w 42480"/>
                <a:gd name="textAreaTop" fmla="*/ 0 h 212400"/>
                <a:gd name="textAreaBottom" fmla="*/ 212760 h 212400"/>
              </a:gdLst>
              <a:ahLst/>
              <a:rect l="textAreaLeft" t="textAreaTop" r="textAreaRight" b="textAreaBottom"/>
              <a:pathLst>
                <a:path w="3615" h="10500">
                  <a:moveTo>
                    <a:pt x="3615" y="0"/>
                  </a:moveTo>
                  <a:cubicBezTo>
                    <a:pt x="1941" y="0"/>
                    <a:pt x="2489" y="10500"/>
                    <a:pt x="827" y="10500"/>
                  </a:cubicBezTo>
                  <a:cubicBezTo>
                    <a:pt x="0" y="10500"/>
                    <a:pt x="0" y="10500"/>
                    <a:pt x="0" y="10500"/>
                  </a:cubicBezTo>
                  <a:cubicBezTo>
                    <a:pt x="1662" y="10500"/>
                    <a:pt x="1117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" name="Freeform 13"/>
            <p:cNvSpPr/>
            <p:nvPr/>
          </p:nvSpPr>
          <p:spPr>
            <a:xfrm>
              <a:off x="5825160" y="5574960"/>
              <a:ext cx="42480" cy="211320"/>
            </a:xfrm>
            <a:custGeom>
              <a:avLst/>
              <a:gdLst>
                <a:gd name="textAreaLeft" fmla="*/ 0 w 42480"/>
                <a:gd name="textAreaRight" fmla="*/ 42840 w 42480"/>
                <a:gd name="textAreaTop" fmla="*/ 0 h 211320"/>
                <a:gd name="textAreaBottom" fmla="*/ 211680 h 211320"/>
              </a:gdLst>
              <a:ahLst/>
              <a:rect l="textAreaLeft" t="textAreaTop" r="textAreaRight" b="textAreaBottom"/>
              <a:pathLst>
                <a:path w="3615" h="10475">
                  <a:moveTo>
                    <a:pt x="3615" y="0"/>
                  </a:moveTo>
                  <a:cubicBezTo>
                    <a:pt x="1942" y="0"/>
                    <a:pt x="2490" y="10475"/>
                    <a:pt x="827" y="10475"/>
                  </a:cubicBezTo>
                  <a:cubicBezTo>
                    <a:pt x="0" y="10475"/>
                    <a:pt x="0" y="10475"/>
                    <a:pt x="0" y="10475"/>
                  </a:cubicBezTo>
                  <a:cubicBezTo>
                    <a:pt x="1663" y="10475"/>
                    <a:pt x="1118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" name="Freeform 9"/>
            <p:cNvSpPr/>
            <p:nvPr/>
          </p:nvSpPr>
          <p:spPr>
            <a:xfrm>
              <a:off x="5759640" y="5574960"/>
              <a:ext cx="42480" cy="211320"/>
            </a:xfrm>
            <a:custGeom>
              <a:avLst/>
              <a:gdLst>
                <a:gd name="textAreaLeft" fmla="*/ 0 w 42480"/>
                <a:gd name="textAreaRight" fmla="*/ 42840 w 42480"/>
                <a:gd name="textAreaTop" fmla="*/ 0 h 211320"/>
                <a:gd name="textAreaBottom" fmla="*/ 211680 h 211320"/>
              </a:gdLst>
              <a:ahLst/>
              <a:rect l="textAreaLeft" t="textAreaTop" r="textAreaRight" b="textAreaBottom"/>
              <a:pathLst>
                <a:path w="3615" h="10475">
                  <a:moveTo>
                    <a:pt x="3615" y="0"/>
                  </a:moveTo>
                  <a:cubicBezTo>
                    <a:pt x="1942" y="0"/>
                    <a:pt x="2489" y="10475"/>
                    <a:pt x="827" y="10475"/>
                  </a:cubicBezTo>
                  <a:cubicBezTo>
                    <a:pt x="0" y="10475"/>
                    <a:pt x="0" y="10475"/>
                    <a:pt x="0" y="10475"/>
                  </a:cubicBezTo>
                  <a:cubicBezTo>
                    <a:pt x="1662" y="10475"/>
                    <a:pt x="1118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" name="Freeform 7"/>
            <p:cNvSpPr/>
            <p:nvPr/>
          </p:nvSpPr>
          <p:spPr>
            <a:xfrm>
              <a:off x="5759640" y="5573880"/>
              <a:ext cx="42480" cy="212400"/>
            </a:xfrm>
            <a:custGeom>
              <a:avLst/>
              <a:gdLst>
                <a:gd name="textAreaLeft" fmla="*/ 0 w 42480"/>
                <a:gd name="textAreaRight" fmla="*/ 42840 w 42480"/>
                <a:gd name="textAreaTop" fmla="*/ 0 h 212400"/>
                <a:gd name="textAreaBottom" fmla="*/ 212760 h 212400"/>
              </a:gdLst>
              <a:ahLst/>
              <a:rect l="textAreaLeft" t="textAreaTop" r="textAreaRight" b="textAreaBottom"/>
              <a:pathLst>
                <a:path w="3607" h="10475">
                  <a:moveTo>
                    <a:pt x="3607" y="10475"/>
                  </a:moveTo>
                  <a:cubicBezTo>
                    <a:pt x="1937" y="10475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475"/>
                    <a:pt x="2782" y="10475"/>
                  </a:cubicBezTo>
                  <a:lnTo>
                    <a:pt x="3607" y="10475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" name="Freeform 11"/>
            <p:cNvSpPr/>
            <p:nvPr/>
          </p:nvSpPr>
          <p:spPr>
            <a:xfrm>
              <a:off x="5825160" y="5573880"/>
              <a:ext cx="42480" cy="210960"/>
            </a:xfrm>
            <a:custGeom>
              <a:avLst/>
              <a:gdLst>
                <a:gd name="textAreaLeft" fmla="*/ 0 w 42480"/>
                <a:gd name="textAreaRight" fmla="*/ 42840 w 42480"/>
                <a:gd name="textAreaTop" fmla="*/ 0 h 210960"/>
                <a:gd name="textAreaBottom" fmla="*/ 211320 h 210960"/>
              </a:gdLst>
              <a:ahLst/>
              <a:rect l="textAreaLeft" t="textAreaTop" r="textAreaRight" b="textAreaBottom"/>
              <a:pathLst>
                <a:path w="3607" h="10475">
                  <a:moveTo>
                    <a:pt x="3607" y="10475"/>
                  </a:moveTo>
                  <a:cubicBezTo>
                    <a:pt x="1937" y="10475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475"/>
                    <a:pt x="2782" y="10475"/>
                  </a:cubicBezTo>
                  <a:lnTo>
                    <a:pt x="3607" y="10475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" name="Freeform 8"/>
            <p:cNvSpPr/>
            <p:nvPr/>
          </p:nvSpPr>
          <p:spPr>
            <a:xfrm>
              <a:off x="5726880" y="5573880"/>
              <a:ext cx="42480" cy="212400"/>
            </a:xfrm>
            <a:custGeom>
              <a:avLst/>
              <a:gdLst>
                <a:gd name="textAreaLeft" fmla="*/ 0 w 42480"/>
                <a:gd name="textAreaRight" fmla="*/ 42840 w 42480"/>
                <a:gd name="textAreaTop" fmla="*/ 0 h 212400"/>
                <a:gd name="textAreaBottom" fmla="*/ 212760 h 212400"/>
              </a:gdLst>
              <a:ahLst/>
              <a:rect l="textAreaLeft" t="textAreaTop" r="textAreaRight" b="textAreaBottom"/>
              <a:pathLst>
                <a:path w="3607" h="10500">
                  <a:moveTo>
                    <a:pt x="3607" y="10500"/>
                  </a:moveTo>
                  <a:cubicBezTo>
                    <a:pt x="1937" y="10500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500"/>
                    <a:pt x="2782" y="10500"/>
                  </a:cubicBezTo>
                  <a:lnTo>
                    <a:pt x="3607" y="1050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" name="Freeform 12"/>
            <p:cNvSpPr/>
            <p:nvPr/>
          </p:nvSpPr>
          <p:spPr>
            <a:xfrm>
              <a:off x="5792040" y="5573880"/>
              <a:ext cx="42480" cy="212400"/>
            </a:xfrm>
            <a:custGeom>
              <a:avLst/>
              <a:gdLst>
                <a:gd name="textAreaLeft" fmla="*/ 0 w 42480"/>
                <a:gd name="textAreaRight" fmla="*/ 42840 w 42480"/>
                <a:gd name="textAreaTop" fmla="*/ 0 h 212400"/>
                <a:gd name="textAreaBottom" fmla="*/ 212760 h 212400"/>
              </a:gdLst>
              <a:ahLst/>
              <a:rect l="textAreaLeft" t="textAreaTop" r="textAreaRight" b="textAreaBottom"/>
              <a:pathLst>
                <a:path w="3607" h="10500">
                  <a:moveTo>
                    <a:pt x="3607" y="10500"/>
                  </a:moveTo>
                  <a:cubicBezTo>
                    <a:pt x="1937" y="10500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500"/>
                    <a:pt x="2782" y="10500"/>
                  </a:cubicBezTo>
                  <a:lnTo>
                    <a:pt x="3607" y="1050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" name="Freeform 14"/>
            <p:cNvSpPr/>
            <p:nvPr/>
          </p:nvSpPr>
          <p:spPr>
            <a:xfrm>
              <a:off x="5921280" y="5573880"/>
              <a:ext cx="42480" cy="212400"/>
            </a:xfrm>
            <a:custGeom>
              <a:avLst/>
              <a:gdLst>
                <a:gd name="textAreaLeft" fmla="*/ 0 w 42480"/>
                <a:gd name="textAreaRight" fmla="*/ 42840 w 42480"/>
                <a:gd name="textAreaTop" fmla="*/ 0 h 212400"/>
                <a:gd name="textAreaBottom" fmla="*/ 212760 h 212400"/>
              </a:gdLst>
              <a:ahLst/>
              <a:rect l="textAreaLeft" t="textAreaTop" r="textAreaRight" b="textAreaBottom"/>
              <a:pathLst>
                <a:path w="3615" h="10500">
                  <a:moveTo>
                    <a:pt x="3615" y="0"/>
                  </a:moveTo>
                  <a:cubicBezTo>
                    <a:pt x="1942" y="0"/>
                    <a:pt x="2489" y="10500"/>
                    <a:pt x="827" y="10500"/>
                  </a:cubicBezTo>
                  <a:cubicBezTo>
                    <a:pt x="0" y="10500"/>
                    <a:pt x="0" y="10500"/>
                    <a:pt x="0" y="10500"/>
                  </a:cubicBezTo>
                  <a:cubicBezTo>
                    <a:pt x="1662" y="10500"/>
                    <a:pt x="1117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" name="Freeform 10"/>
            <p:cNvSpPr/>
            <p:nvPr/>
          </p:nvSpPr>
          <p:spPr>
            <a:xfrm>
              <a:off x="5856120" y="5573880"/>
              <a:ext cx="42480" cy="212400"/>
            </a:xfrm>
            <a:custGeom>
              <a:avLst/>
              <a:gdLst>
                <a:gd name="textAreaLeft" fmla="*/ 0 w 42480"/>
                <a:gd name="textAreaRight" fmla="*/ 42840 w 42480"/>
                <a:gd name="textAreaTop" fmla="*/ 0 h 212400"/>
                <a:gd name="textAreaBottom" fmla="*/ 212760 h 212400"/>
              </a:gdLst>
              <a:ahLst/>
              <a:rect l="textAreaLeft" t="textAreaTop" r="textAreaRight" b="textAreaBottom"/>
              <a:pathLst>
                <a:path w="3615" h="10500">
                  <a:moveTo>
                    <a:pt x="3615" y="0"/>
                  </a:moveTo>
                  <a:cubicBezTo>
                    <a:pt x="1941" y="0"/>
                    <a:pt x="2489" y="10500"/>
                    <a:pt x="827" y="10500"/>
                  </a:cubicBezTo>
                  <a:cubicBezTo>
                    <a:pt x="0" y="10500"/>
                    <a:pt x="0" y="10500"/>
                    <a:pt x="0" y="10500"/>
                  </a:cubicBezTo>
                  <a:cubicBezTo>
                    <a:pt x="1662" y="10500"/>
                    <a:pt x="1117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" name="Freeform 13"/>
            <p:cNvSpPr/>
            <p:nvPr/>
          </p:nvSpPr>
          <p:spPr>
            <a:xfrm>
              <a:off x="5954400" y="5574960"/>
              <a:ext cx="42480" cy="211320"/>
            </a:xfrm>
            <a:custGeom>
              <a:avLst/>
              <a:gdLst>
                <a:gd name="textAreaLeft" fmla="*/ 0 w 42480"/>
                <a:gd name="textAreaRight" fmla="*/ 42840 w 42480"/>
                <a:gd name="textAreaTop" fmla="*/ 0 h 211320"/>
                <a:gd name="textAreaBottom" fmla="*/ 211680 h 211320"/>
              </a:gdLst>
              <a:ahLst/>
              <a:rect l="textAreaLeft" t="textAreaTop" r="textAreaRight" b="textAreaBottom"/>
              <a:pathLst>
                <a:path w="3615" h="10475">
                  <a:moveTo>
                    <a:pt x="3615" y="0"/>
                  </a:moveTo>
                  <a:cubicBezTo>
                    <a:pt x="1942" y="0"/>
                    <a:pt x="2490" y="10475"/>
                    <a:pt x="827" y="10475"/>
                  </a:cubicBezTo>
                  <a:cubicBezTo>
                    <a:pt x="0" y="10475"/>
                    <a:pt x="0" y="10475"/>
                    <a:pt x="0" y="10475"/>
                  </a:cubicBezTo>
                  <a:cubicBezTo>
                    <a:pt x="1663" y="10475"/>
                    <a:pt x="1118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" name="Freeform 9"/>
            <p:cNvSpPr/>
            <p:nvPr/>
          </p:nvSpPr>
          <p:spPr>
            <a:xfrm>
              <a:off x="5889240" y="5574960"/>
              <a:ext cx="42480" cy="211320"/>
            </a:xfrm>
            <a:custGeom>
              <a:avLst/>
              <a:gdLst>
                <a:gd name="textAreaLeft" fmla="*/ 0 w 42480"/>
                <a:gd name="textAreaRight" fmla="*/ 42840 w 42480"/>
                <a:gd name="textAreaTop" fmla="*/ 0 h 211320"/>
                <a:gd name="textAreaBottom" fmla="*/ 211680 h 211320"/>
              </a:gdLst>
              <a:ahLst/>
              <a:rect l="textAreaLeft" t="textAreaTop" r="textAreaRight" b="textAreaBottom"/>
              <a:pathLst>
                <a:path w="3615" h="10475">
                  <a:moveTo>
                    <a:pt x="3615" y="0"/>
                  </a:moveTo>
                  <a:cubicBezTo>
                    <a:pt x="1942" y="0"/>
                    <a:pt x="2489" y="10475"/>
                    <a:pt x="827" y="10475"/>
                  </a:cubicBezTo>
                  <a:cubicBezTo>
                    <a:pt x="0" y="10475"/>
                    <a:pt x="0" y="10475"/>
                    <a:pt x="0" y="10475"/>
                  </a:cubicBezTo>
                  <a:cubicBezTo>
                    <a:pt x="1662" y="10475"/>
                    <a:pt x="1118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" name="Freeform 7"/>
            <p:cNvSpPr/>
            <p:nvPr/>
          </p:nvSpPr>
          <p:spPr>
            <a:xfrm>
              <a:off x="5889240" y="5573880"/>
              <a:ext cx="42480" cy="212400"/>
            </a:xfrm>
            <a:custGeom>
              <a:avLst/>
              <a:gdLst>
                <a:gd name="textAreaLeft" fmla="*/ 0 w 42480"/>
                <a:gd name="textAreaRight" fmla="*/ 42840 w 42480"/>
                <a:gd name="textAreaTop" fmla="*/ 0 h 212400"/>
                <a:gd name="textAreaBottom" fmla="*/ 212760 h 212400"/>
              </a:gdLst>
              <a:ahLst/>
              <a:rect l="textAreaLeft" t="textAreaTop" r="textAreaRight" b="textAreaBottom"/>
              <a:pathLst>
                <a:path w="3607" h="10475">
                  <a:moveTo>
                    <a:pt x="3607" y="10475"/>
                  </a:moveTo>
                  <a:cubicBezTo>
                    <a:pt x="1937" y="10475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475"/>
                    <a:pt x="2782" y="10475"/>
                  </a:cubicBezTo>
                  <a:lnTo>
                    <a:pt x="3607" y="10475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" name="Freeform 11"/>
            <p:cNvSpPr/>
            <p:nvPr/>
          </p:nvSpPr>
          <p:spPr>
            <a:xfrm>
              <a:off x="5954400" y="5573880"/>
              <a:ext cx="42480" cy="210960"/>
            </a:xfrm>
            <a:custGeom>
              <a:avLst/>
              <a:gdLst>
                <a:gd name="textAreaLeft" fmla="*/ 0 w 42480"/>
                <a:gd name="textAreaRight" fmla="*/ 42840 w 42480"/>
                <a:gd name="textAreaTop" fmla="*/ 0 h 210960"/>
                <a:gd name="textAreaBottom" fmla="*/ 211320 h 210960"/>
              </a:gdLst>
              <a:ahLst/>
              <a:rect l="textAreaLeft" t="textAreaTop" r="textAreaRight" b="textAreaBottom"/>
              <a:pathLst>
                <a:path w="3607" h="10475">
                  <a:moveTo>
                    <a:pt x="3607" y="10475"/>
                  </a:moveTo>
                  <a:cubicBezTo>
                    <a:pt x="1937" y="10475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475"/>
                    <a:pt x="2782" y="10475"/>
                  </a:cubicBezTo>
                  <a:lnTo>
                    <a:pt x="3607" y="10475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" name="Freeform 8"/>
            <p:cNvSpPr/>
            <p:nvPr/>
          </p:nvSpPr>
          <p:spPr>
            <a:xfrm>
              <a:off x="5856120" y="5573880"/>
              <a:ext cx="42480" cy="212400"/>
            </a:xfrm>
            <a:custGeom>
              <a:avLst/>
              <a:gdLst>
                <a:gd name="textAreaLeft" fmla="*/ 0 w 42480"/>
                <a:gd name="textAreaRight" fmla="*/ 42840 w 42480"/>
                <a:gd name="textAreaTop" fmla="*/ 0 h 212400"/>
                <a:gd name="textAreaBottom" fmla="*/ 212760 h 212400"/>
              </a:gdLst>
              <a:ahLst/>
              <a:rect l="textAreaLeft" t="textAreaTop" r="textAreaRight" b="textAreaBottom"/>
              <a:pathLst>
                <a:path w="3607" h="10500">
                  <a:moveTo>
                    <a:pt x="3607" y="10500"/>
                  </a:moveTo>
                  <a:cubicBezTo>
                    <a:pt x="1937" y="10500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500"/>
                    <a:pt x="2782" y="10500"/>
                  </a:cubicBezTo>
                  <a:lnTo>
                    <a:pt x="3607" y="1050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" name="Freeform 12"/>
            <p:cNvSpPr/>
            <p:nvPr/>
          </p:nvSpPr>
          <p:spPr>
            <a:xfrm>
              <a:off x="5921280" y="5573880"/>
              <a:ext cx="42480" cy="212400"/>
            </a:xfrm>
            <a:custGeom>
              <a:avLst/>
              <a:gdLst>
                <a:gd name="textAreaLeft" fmla="*/ 0 w 42480"/>
                <a:gd name="textAreaRight" fmla="*/ 42840 w 42480"/>
                <a:gd name="textAreaTop" fmla="*/ 0 h 212400"/>
                <a:gd name="textAreaBottom" fmla="*/ 212760 h 212400"/>
              </a:gdLst>
              <a:ahLst/>
              <a:rect l="textAreaLeft" t="textAreaTop" r="textAreaRight" b="textAreaBottom"/>
              <a:pathLst>
                <a:path w="3607" h="10500">
                  <a:moveTo>
                    <a:pt x="3607" y="10500"/>
                  </a:moveTo>
                  <a:cubicBezTo>
                    <a:pt x="1937" y="10500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500"/>
                    <a:pt x="2782" y="10500"/>
                  </a:cubicBezTo>
                  <a:lnTo>
                    <a:pt x="3607" y="1050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" name="Freeform 14"/>
            <p:cNvSpPr/>
            <p:nvPr/>
          </p:nvSpPr>
          <p:spPr>
            <a:xfrm>
              <a:off x="6053040" y="5573880"/>
              <a:ext cx="42480" cy="212400"/>
            </a:xfrm>
            <a:custGeom>
              <a:avLst/>
              <a:gdLst>
                <a:gd name="textAreaLeft" fmla="*/ 0 w 42480"/>
                <a:gd name="textAreaRight" fmla="*/ 42840 w 42480"/>
                <a:gd name="textAreaTop" fmla="*/ 0 h 212400"/>
                <a:gd name="textAreaBottom" fmla="*/ 212760 h 212400"/>
              </a:gdLst>
              <a:ahLst/>
              <a:rect l="textAreaLeft" t="textAreaTop" r="textAreaRight" b="textAreaBottom"/>
              <a:pathLst>
                <a:path w="3615" h="10500">
                  <a:moveTo>
                    <a:pt x="3615" y="0"/>
                  </a:moveTo>
                  <a:cubicBezTo>
                    <a:pt x="1942" y="0"/>
                    <a:pt x="2489" y="10500"/>
                    <a:pt x="827" y="10500"/>
                  </a:cubicBezTo>
                  <a:cubicBezTo>
                    <a:pt x="0" y="10500"/>
                    <a:pt x="0" y="10500"/>
                    <a:pt x="0" y="10500"/>
                  </a:cubicBezTo>
                  <a:cubicBezTo>
                    <a:pt x="1662" y="10500"/>
                    <a:pt x="1117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" name="Freeform 10"/>
            <p:cNvSpPr/>
            <p:nvPr/>
          </p:nvSpPr>
          <p:spPr>
            <a:xfrm>
              <a:off x="5987520" y="5573880"/>
              <a:ext cx="42480" cy="212400"/>
            </a:xfrm>
            <a:custGeom>
              <a:avLst/>
              <a:gdLst>
                <a:gd name="textAreaLeft" fmla="*/ 0 w 42480"/>
                <a:gd name="textAreaRight" fmla="*/ 42840 w 42480"/>
                <a:gd name="textAreaTop" fmla="*/ 0 h 212400"/>
                <a:gd name="textAreaBottom" fmla="*/ 212760 h 212400"/>
              </a:gdLst>
              <a:ahLst/>
              <a:rect l="textAreaLeft" t="textAreaTop" r="textAreaRight" b="textAreaBottom"/>
              <a:pathLst>
                <a:path w="3615" h="10500">
                  <a:moveTo>
                    <a:pt x="3615" y="0"/>
                  </a:moveTo>
                  <a:cubicBezTo>
                    <a:pt x="1941" y="0"/>
                    <a:pt x="2489" y="10500"/>
                    <a:pt x="827" y="10500"/>
                  </a:cubicBezTo>
                  <a:cubicBezTo>
                    <a:pt x="0" y="10500"/>
                    <a:pt x="0" y="10500"/>
                    <a:pt x="0" y="10500"/>
                  </a:cubicBezTo>
                  <a:cubicBezTo>
                    <a:pt x="1662" y="10500"/>
                    <a:pt x="1117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" name="Freeform 13"/>
            <p:cNvSpPr/>
            <p:nvPr/>
          </p:nvSpPr>
          <p:spPr>
            <a:xfrm>
              <a:off x="6086160" y="5574960"/>
              <a:ext cx="42480" cy="211320"/>
            </a:xfrm>
            <a:custGeom>
              <a:avLst/>
              <a:gdLst>
                <a:gd name="textAreaLeft" fmla="*/ 0 w 42480"/>
                <a:gd name="textAreaRight" fmla="*/ 42840 w 42480"/>
                <a:gd name="textAreaTop" fmla="*/ 0 h 211320"/>
                <a:gd name="textAreaBottom" fmla="*/ 211680 h 211320"/>
              </a:gdLst>
              <a:ahLst/>
              <a:rect l="textAreaLeft" t="textAreaTop" r="textAreaRight" b="textAreaBottom"/>
              <a:pathLst>
                <a:path w="3615" h="10475">
                  <a:moveTo>
                    <a:pt x="3615" y="0"/>
                  </a:moveTo>
                  <a:cubicBezTo>
                    <a:pt x="1942" y="0"/>
                    <a:pt x="2490" y="10475"/>
                    <a:pt x="827" y="10475"/>
                  </a:cubicBezTo>
                  <a:cubicBezTo>
                    <a:pt x="0" y="10475"/>
                    <a:pt x="0" y="10475"/>
                    <a:pt x="0" y="10475"/>
                  </a:cubicBezTo>
                  <a:cubicBezTo>
                    <a:pt x="1663" y="10475"/>
                    <a:pt x="1118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" name="Freeform 9"/>
            <p:cNvSpPr/>
            <p:nvPr/>
          </p:nvSpPr>
          <p:spPr>
            <a:xfrm>
              <a:off x="6020640" y="5574960"/>
              <a:ext cx="42480" cy="211320"/>
            </a:xfrm>
            <a:custGeom>
              <a:avLst/>
              <a:gdLst>
                <a:gd name="textAreaLeft" fmla="*/ 0 w 42480"/>
                <a:gd name="textAreaRight" fmla="*/ 42840 w 42480"/>
                <a:gd name="textAreaTop" fmla="*/ 0 h 211320"/>
                <a:gd name="textAreaBottom" fmla="*/ 211680 h 211320"/>
              </a:gdLst>
              <a:ahLst/>
              <a:rect l="textAreaLeft" t="textAreaTop" r="textAreaRight" b="textAreaBottom"/>
              <a:pathLst>
                <a:path w="3615" h="10475">
                  <a:moveTo>
                    <a:pt x="3615" y="0"/>
                  </a:moveTo>
                  <a:cubicBezTo>
                    <a:pt x="1942" y="0"/>
                    <a:pt x="2489" y="10475"/>
                    <a:pt x="827" y="10475"/>
                  </a:cubicBezTo>
                  <a:cubicBezTo>
                    <a:pt x="0" y="10475"/>
                    <a:pt x="0" y="10475"/>
                    <a:pt x="0" y="10475"/>
                  </a:cubicBezTo>
                  <a:cubicBezTo>
                    <a:pt x="1662" y="10475"/>
                    <a:pt x="1118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" name="Freeform 7"/>
            <p:cNvSpPr/>
            <p:nvPr/>
          </p:nvSpPr>
          <p:spPr>
            <a:xfrm>
              <a:off x="6020640" y="5573880"/>
              <a:ext cx="42480" cy="212400"/>
            </a:xfrm>
            <a:custGeom>
              <a:avLst/>
              <a:gdLst>
                <a:gd name="textAreaLeft" fmla="*/ 0 w 42480"/>
                <a:gd name="textAreaRight" fmla="*/ 42840 w 42480"/>
                <a:gd name="textAreaTop" fmla="*/ 0 h 212400"/>
                <a:gd name="textAreaBottom" fmla="*/ 212760 h 212400"/>
              </a:gdLst>
              <a:ahLst/>
              <a:rect l="textAreaLeft" t="textAreaTop" r="textAreaRight" b="textAreaBottom"/>
              <a:pathLst>
                <a:path w="3607" h="10475">
                  <a:moveTo>
                    <a:pt x="3607" y="10475"/>
                  </a:moveTo>
                  <a:cubicBezTo>
                    <a:pt x="1937" y="10475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475"/>
                    <a:pt x="2782" y="10475"/>
                  </a:cubicBezTo>
                  <a:lnTo>
                    <a:pt x="3607" y="10475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" name="Freeform 11"/>
            <p:cNvSpPr/>
            <p:nvPr/>
          </p:nvSpPr>
          <p:spPr>
            <a:xfrm>
              <a:off x="6086160" y="5573880"/>
              <a:ext cx="42480" cy="210960"/>
            </a:xfrm>
            <a:custGeom>
              <a:avLst/>
              <a:gdLst>
                <a:gd name="textAreaLeft" fmla="*/ 0 w 42480"/>
                <a:gd name="textAreaRight" fmla="*/ 42840 w 42480"/>
                <a:gd name="textAreaTop" fmla="*/ 0 h 210960"/>
                <a:gd name="textAreaBottom" fmla="*/ 211320 h 210960"/>
              </a:gdLst>
              <a:ahLst/>
              <a:rect l="textAreaLeft" t="textAreaTop" r="textAreaRight" b="textAreaBottom"/>
              <a:pathLst>
                <a:path w="3607" h="10475">
                  <a:moveTo>
                    <a:pt x="3607" y="10475"/>
                  </a:moveTo>
                  <a:cubicBezTo>
                    <a:pt x="1937" y="10475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475"/>
                    <a:pt x="2782" y="10475"/>
                  </a:cubicBezTo>
                  <a:lnTo>
                    <a:pt x="3607" y="10475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" name="Freeform 8"/>
            <p:cNvSpPr/>
            <p:nvPr/>
          </p:nvSpPr>
          <p:spPr>
            <a:xfrm>
              <a:off x="5987520" y="5573880"/>
              <a:ext cx="42480" cy="212400"/>
            </a:xfrm>
            <a:custGeom>
              <a:avLst/>
              <a:gdLst>
                <a:gd name="textAreaLeft" fmla="*/ 0 w 42480"/>
                <a:gd name="textAreaRight" fmla="*/ 42840 w 42480"/>
                <a:gd name="textAreaTop" fmla="*/ 0 h 212400"/>
                <a:gd name="textAreaBottom" fmla="*/ 212760 h 212400"/>
              </a:gdLst>
              <a:ahLst/>
              <a:rect l="textAreaLeft" t="textAreaTop" r="textAreaRight" b="textAreaBottom"/>
              <a:pathLst>
                <a:path w="3607" h="10500">
                  <a:moveTo>
                    <a:pt x="3607" y="10500"/>
                  </a:moveTo>
                  <a:cubicBezTo>
                    <a:pt x="1937" y="10500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500"/>
                    <a:pt x="2782" y="10500"/>
                  </a:cubicBezTo>
                  <a:lnTo>
                    <a:pt x="3607" y="1050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" name="Freeform 12"/>
            <p:cNvSpPr/>
            <p:nvPr/>
          </p:nvSpPr>
          <p:spPr>
            <a:xfrm>
              <a:off x="6053040" y="5573880"/>
              <a:ext cx="42480" cy="212400"/>
            </a:xfrm>
            <a:custGeom>
              <a:avLst/>
              <a:gdLst>
                <a:gd name="textAreaLeft" fmla="*/ 0 w 42480"/>
                <a:gd name="textAreaRight" fmla="*/ 42840 w 42480"/>
                <a:gd name="textAreaTop" fmla="*/ 0 h 212400"/>
                <a:gd name="textAreaBottom" fmla="*/ 212760 h 212400"/>
              </a:gdLst>
              <a:ahLst/>
              <a:rect l="textAreaLeft" t="textAreaTop" r="textAreaRight" b="textAreaBottom"/>
              <a:pathLst>
                <a:path w="3607" h="10500">
                  <a:moveTo>
                    <a:pt x="3607" y="10500"/>
                  </a:moveTo>
                  <a:cubicBezTo>
                    <a:pt x="1937" y="10500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500"/>
                    <a:pt x="2782" y="10500"/>
                  </a:cubicBezTo>
                  <a:lnTo>
                    <a:pt x="3607" y="1050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" name="Freeform 14"/>
            <p:cNvSpPr/>
            <p:nvPr/>
          </p:nvSpPr>
          <p:spPr>
            <a:xfrm>
              <a:off x="6183000" y="5573880"/>
              <a:ext cx="42480" cy="212400"/>
            </a:xfrm>
            <a:custGeom>
              <a:avLst/>
              <a:gdLst>
                <a:gd name="textAreaLeft" fmla="*/ 0 w 42480"/>
                <a:gd name="textAreaRight" fmla="*/ 42840 w 42480"/>
                <a:gd name="textAreaTop" fmla="*/ 0 h 212400"/>
                <a:gd name="textAreaBottom" fmla="*/ 212760 h 212400"/>
              </a:gdLst>
              <a:ahLst/>
              <a:rect l="textAreaLeft" t="textAreaTop" r="textAreaRight" b="textAreaBottom"/>
              <a:pathLst>
                <a:path w="3615" h="10500">
                  <a:moveTo>
                    <a:pt x="3615" y="0"/>
                  </a:moveTo>
                  <a:cubicBezTo>
                    <a:pt x="1942" y="0"/>
                    <a:pt x="2489" y="10500"/>
                    <a:pt x="827" y="10500"/>
                  </a:cubicBezTo>
                  <a:cubicBezTo>
                    <a:pt x="0" y="10500"/>
                    <a:pt x="0" y="10500"/>
                    <a:pt x="0" y="10500"/>
                  </a:cubicBezTo>
                  <a:cubicBezTo>
                    <a:pt x="1662" y="10500"/>
                    <a:pt x="1117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8" name="Freeform 10"/>
            <p:cNvSpPr/>
            <p:nvPr/>
          </p:nvSpPr>
          <p:spPr>
            <a:xfrm>
              <a:off x="6117840" y="5573880"/>
              <a:ext cx="42480" cy="212400"/>
            </a:xfrm>
            <a:custGeom>
              <a:avLst/>
              <a:gdLst>
                <a:gd name="textAreaLeft" fmla="*/ 0 w 42480"/>
                <a:gd name="textAreaRight" fmla="*/ 42840 w 42480"/>
                <a:gd name="textAreaTop" fmla="*/ 0 h 212400"/>
                <a:gd name="textAreaBottom" fmla="*/ 212760 h 212400"/>
              </a:gdLst>
              <a:ahLst/>
              <a:rect l="textAreaLeft" t="textAreaTop" r="textAreaRight" b="textAreaBottom"/>
              <a:pathLst>
                <a:path w="3615" h="10500">
                  <a:moveTo>
                    <a:pt x="3615" y="0"/>
                  </a:moveTo>
                  <a:cubicBezTo>
                    <a:pt x="1941" y="0"/>
                    <a:pt x="2489" y="10500"/>
                    <a:pt x="827" y="10500"/>
                  </a:cubicBezTo>
                  <a:cubicBezTo>
                    <a:pt x="0" y="10500"/>
                    <a:pt x="0" y="10500"/>
                    <a:pt x="0" y="10500"/>
                  </a:cubicBezTo>
                  <a:cubicBezTo>
                    <a:pt x="1662" y="10500"/>
                    <a:pt x="1117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9" name="Freeform 13"/>
            <p:cNvSpPr/>
            <p:nvPr/>
          </p:nvSpPr>
          <p:spPr>
            <a:xfrm>
              <a:off x="6216120" y="5574960"/>
              <a:ext cx="42480" cy="211320"/>
            </a:xfrm>
            <a:custGeom>
              <a:avLst/>
              <a:gdLst>
                <a:gd name="textAreaLeft" fmla="*/ 0 w 42480"/>
                <a:gd name="textAreaRight" fmla="*/ 42840 w 42480"/>
                <a:gd name="textAreaTop" fmla="*/ 0 h 211320"/>
                <a:gd name="textAreaBottom" fmla="*/ 211680 h 211320"/>
              </a:gdLst>
              <a:ahLst/>
              <a:rect l="textAreaLeft" t="textAreaTop" r="textAreaRight" b="textAreaBottom"/>
              <a:pathLst>
                <a:path w="3615" h="10475">
                  <a:moveTo>
                    <a:pt x="3615" y="0"/>
                  </a:moveTo>
                  <a:cubicBezTo>
                    <a:pt x="1942" y="0"/>
                    <a:pt x="2490" y="10475"/>
                    <a:pt x="827" y="10475"/>
                  </a:cubicBezTo>
                  <a:cubicBezTo>
                    <a:pt x="0" y="10475"/>
                    <a:pt x="0" y="10475"/>
                    <a:pt x="0" y="10475"/>
                  </a:cubicBezTo>
                  <a:cubicBezTo>
                    <a:pt x="1663" y="10475"/>
                    <a:pt x="1118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0" name="Freeform 9"/>
            <p:cNvSpPr/>
            <p:nvPr/>
          </p:nvSpPr>
          <p:spPr>
            <a:xfrm>
              <a:off x="6150600" y="5574960"/>
              <a:ext cx="42480" cy="211320"/>
            </a:xfrm>
            <a:custGeom>
              <a:avLst/>
              <a:gdLst>
                <a:gd name="textAreaLeft" fmla="*/ 0 w 42480"/>
                <a:gd name="textAreaRight" fmla="*/ 42840 w 42480"/>
                <a:gd name="textAreaTop" fmla="*/ 0 h 211320"/>
                <a:gd name="textAreaBottom" fmla="*/ 211680 h 211320"/>
              </a:gdLst>
              <a:ahLst/>
              <a:rect l="textAreaLeft" t="textAreaTop" r="textAreaRight" b="textAreaBottom"/>
              <a:pathLst>
                <a:path w="3615" h="10475">
                  <a:moveTo>
                    <a:pt x="3615" y="0"/>
                  </a:moveTo>
                  <a:cubicBezTo>
                    <a:pt x="1942" y="0"/>
                    <a:pt x="2489" y="10475"/>
                    <a:pt x="827" y="10475"/>
                  </a:cubicBezTo>
                  <a:cubicBezTo>
                    <a:pt x="0" y="10475"/>
                    <a:pt x="0" y="10475"/>
                    <a:pt x="0" y="10475"/>
                  </a:cubicBezTo>
                  <a:cubicBezTo>
                    <a:pt x="1662" y="10475"/>
                    <a:pt x="1118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1" name="Freeform 7"/>
            <p:cNvSpPr/>
            <p:nvPr/>
          </p:nvSpPr>
          <p:spPr>
            <a:xfrm>
              <a:off x="6150600" y="5573880"/>
              <a:ext cx="42480" cy="212400"/>
            </a:xfrm>
            <a:custGeom>
              <a:avLst/>
              <a:gdLst>
                <a:gd name="textAreaLeft" fmla="*/ 0 w 42480"/>
                <a:gd name="textAreaRight" fmla="*/ 42840 w 42480"/>
                <a:gd name="textAreaTop" fmla="*/ 0 h 212400"/>
                <a:gd name="textAreaBottom" fmla="*/ 212760 h 212400"/>
              </a:gdLst>
              <a:ahLst/>
              <a:rect l="textAreaLeft" t="textAreaTop" r="textAreaRight" b="textAreaBottom"/>
              <a:pathLst>
                <a:path w="3607" h="10475">
                  <a:moveTo>
                    <a:pt x="3607" y="10475"/>
                  </a:moveTo>
                  <a:cubicBezTo>
                    <a:pt x="1937" y="10475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475"/>
                    <a:pt x="2782" y="10475"/>
                  </a:cubicBezTo>
                  <a:lnTo>
                    <a:pt x="3607" y="10475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2" name="Freeform 11"/>
            <p:cNvSpPr/>
            <p:nvPr/>
          </p:nvSpPr>
          <p:spPr>
            <a:xfrm>
              <a:off x="6216120" y="5573880"/>
              <a:ext cx="42480" cy="210960"/>
            </a:xfrm>
            <a:custGeom>
              <a:avLst/>
              <a:gdLst>
                <a:gd name="textAreaLeft" fmla="*/ 0 w 42480"/>
                <a:gd name="textAreaRight" fmla="*/ 42840 w 42480"/>
                <a:gd name="textAreaTop" fmla="*/ 0 h 210960"/>
                <a:gd name="textAreaBottom" fmla="*/ 211320 h 210960"/>
              </a:gdLst>
              <a:ahLst/>
              <a:rect l="textAreaLeft" t="textAreaTop" r="textAreaRight" b="textAreaBottom"/>
              <a:pathLst>
                <a:path w="3607" h="10475">
                  <a:moveTo>
                    <a:pt x="3607" y="10475"/>
                  </a:moveTo>
                  <a:cubicBezTo>
                    <a:pt x="1937" y="10475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475"/>
                    <a:pt x="2782" y="10475"/>
                  </a:cubicBezTo>
                  <a:lnTo>
                    <a:pt x="3607" y="10475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3" name="Freeform 8"/>
            <p:cNvSpPr/>
            <p:nvPr/>
          </p:nvSpPr>
          <p:spPr>
            <a:xfrm>
              <a:off x="6117840" y="5573880"/>
              <a:ext cx="42480" cy="212400"/>
            </a:xfrm>
            <a:custGeom>
              <a:avLst/>
              <a:gdLst>
                <a:gd name="textAreaLeft" fmla="*/ 0 w 42480"/>
                <a:gd name="textAreaRight" fmla="*/ 42840 w 42480"/>
                <a:gd name="textAreaTop" fmla="*/ 0 h 212400"/>
                <a:gd name="textAreaBottom" fmla="*/ 212760 h 212400"/>
              </a:gdLst>
              <a:ahLst/>
              <a:rect l="textAreaLeft" t="textAreaTop" r="textAreaRight" b="textAreaBottom"/>
              <a:pathLst>
                <a:path w="3607" h="10500">
                  <a:moveTo>
                    <a:pt x="3607" y="10500"/>
                  </a:moveTo>
                  <a:cubicBezTo>
                    <a:pt x="1937" y="10500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500"/>
                    <a:pt x="2782" y="10500"/>
                  </a:cubicBezTo>
                  <a:lnTo>
                    <a:pt x="3607" y="1050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4" name="Freeform 12"/>
            <p:cNvSpPr/>
            <p:nvPr/>
          </p:nvSpPr>
          <p:spPr>
            <a:xfrm>
              <a:off x="6183000" y="5573880"/>
              <a:ext cx="42480" cy="212400"/>
            </a:xfrm>
            <a:custGeom>
              <a:avLst/>
              <a:gdLst>
                <a:gd name="textAreaLeft" fmla="*/ 0 w 42480"/>
                <a:gd name="textAreaRight" fmla="*/ 42840 w 42480"/>
                <a:gd name="textAreaTop" fmla="*/ 0 h 212400"/>
                <a:gd name="textAreaBottom" fmla="*/ 212760 h 212400"/>
              </a:gdLst>
              <a:ahLst/>
              <a:rect l="textAreaLeft" t="textAreaTop" r="textAreaRight" b="textAreaBottom"/>
              <a:pathLst>
                <a:path w="3607" h="10500">
                  <a:moveTo>
                    <a:pt x="3607" y="10500"/>
                  </a:moveTo>
                  <a:cubicBezTo>
                    <a:pt x="1937" y="10500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500"/>
                    <a:pt x="2782" y="10500"/>
                  </a:cubicBezTo>
                  <a:lnTo>
                    <a:pt x="3607" y="1050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5" name="Freeform 14"/>
            <p:cNvSpPr/>
            <p:nvPr/>
          </p:nvSpPr>
          <p:spPr>
            <a:xfrm>
              <a:off x="6315840" y="5573880"/>
              <a:ext cx="42480" cy="212400"/>
            </a:xfrm>
            <a:custGeom>
              <a:avLst/>
              <a:gdLst>
                <a:gd name="textAreaLeft" fmla="*/ 0 w 42480"/>
                <a:gd name="textAreaRight" fmla="*/ 42840 w 42480"/>
                <a:gd name="textAreaTop" fmla="*/ 0 h 212400"/>
                <a:gd name="textAreaBottom" fmla="*/ 212760 h 212400"/>
              </a:gdLst>
              <a:ahLst/>
              <a:rect l="textAreaLeft" t="textAreaTop" r="textAreaRight" b="textAreaBottom"/>
              <a:pathLst>
                <a:path w="3615" h="10500">
                  <a:moveTo>
                    <a:pt x="3615" y="0"/>
                  </a:moveTo>
                  <a:cubicBezTo>
                    <a:pt x="1942" y="0"/>
                    <a:pt x="2489" y="10500"/>
                    <a:pt x="827" y="10500"/>
                  </a:cubicBezTo>
                  <a:cubicBezTo>
                    <a:pt x="0" y="10500"/>
                    <a:pt x="0" y="10500"/>
                    <a:pt x="0" y="10500"/>
                  </a:cubicBezTo>
                  <a:cubicBezTo>
                    <a:pt x="1662" y="10500"/>
                    <a:pt x="1117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6" name="Freeform 10"/>
            <p:cNvSpPr/>
            <p:nvPr/>
          </p:nvSpPr>
          <p:spPr>
            <a:xfrm>
              <a:off x="6250680" y="5573880"/>
              <a:ext cx="42480" cy="212400"/>
            </a:xfrm>
            <a:custGeom>
              <a:avLst/>
              <a:gdLst>
                <a:gd name="textAreaLeft" fmla="*/ 0 w 42480"/>
                <a:gd name="textAreaRight" fmla="*/ 42840 w 42480"/>
                <a:gd name="textAreaTop" fmla="*/ 0 h 212400"/>
                <a:gd name="textAreaBottom" fmla="*/ 212760 h 212400"/>
              </a:gdLst>
              <a:ahLst/>
              <a:rect l="textAreaLeft" t="textAreaTop" r="textAreaRight" b="textAreaBottom"/>
              <a:pathLst>
                <a:path w="3615" h="10500">
                  <a:moveTo>
                    <a:pt x="3615" y="0"/>
                  </a:moveTo>
                  <a:cubicBezTo>
                    <a:pt x="1941" y="0"/>
                    <a:pt x="2489" y="10500"/>
                    <a:pt x="827" y="10500"/>
                  </a:cubicBezTo>
                  <a:cubicBezTo>
                    <a:pt x="0" y="10500"/>
                    <a:pt x="0" y="10500"/>
                    <a:pt x="0" y="10500"/>
                  </a:cubicBezTo>
                  <a:cubicBezTo>
                    <a:pt x="1662" y="10500"/>
                    <a:pt x="1117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7" name="Freeform 13"/>
            <p:cNvSpPr/>
            <p:nvPr/>
          </p:nvSpPr>
          <p:spPr>
            <a:xfrm>
              <a:off x="6349320" y="5574960"/>
              <a:ext cx="42480" cy="211320"/>
            </a:xfrm>
            <a:custGeom>
              <a:avLst/>
              <a:gdLst>
                <a:gd name="textAreaLeft" fmla="*/ 0 w 42480"/>
                <a:gd name="textAreaRight" fmla="*/ 42840 w 42480"/>
                <a:gd name="textAreaTop" fmla="*/ 0 h 211320"/>
                <a:gd name="textAreaBottom" fmla="*/ 211680 h 211320"/>
              </a:gdLst>
              <a:ahLst/>
              <a:rect l="textAreaLeft" t="textAreaTop" r="textAreaRight" b="textAreaBottom"/>
              <a:pathLst>
                <a:path w="3615" h="10475">
                  <a:moveTo>
                    <a:pt x="3615" y="0"/>
                  </a:moveTo>
                  <a:cubicBezTo>
                    <a:pt x="1942" y="0"/>
                    <a:pt x="2490" y="10475"/>
                    <a:pt x="827" y="10475"/>
                  </a:cubicBezTo>
                  <a:cubicBezTo>
                    <a:pt x="0" y="10475"/>
                    <a:pt x="0" y="10475"/>
                    <a:pt x="0" y="10475"/>
                  </a:cubicBezTo>
                  <a:cubicBezTo>
                    <a:pt x="1663" y="10475"/>
                    <a:pt x="1118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8" name="Freeform 9"/>
            <p:cNvSpPr/>
            <p:nvPr/>
          </p:nvSpPr>
          <p:spPr>
            <a:xfrm>
              <a:off x="6283800" y="5574960"/>
              <a:ext cx="42480" cy="211320"/>
            </a:xfrm>
            <a:custGeom>
              <a:avLst/>
              <a:gdLst>
                <a:gd name="textAreaLeft" fmla="*/ 0 w 42480"/>
                <a:gd name="textAreaRight" fmla="*/ 42840 w 42480"/>
                <a:gd name="textAreaTop" fmla="*/ 0 h 211320"/>
                <a:gd name="textAreaBottom" fmla="*/ 211680 h 211320"/>
              </a:gdLst>
              <a:ahLst/>
              <a:rect l="textAreaLeft" t="textAreaTop" r="textAreaRight" b="textAreaBottom"/>
              <a:pathLst>
                <a:path w="3615" h="10475">
                  <a:moveTo>
                    <a:pt x="3615" y="0"/>
                  </a:moveTo>
                  <a:cubicBezTo>
                    <a:pt x="1942" y="0"/>
                    <a:pt x="2489" y="10475"/>
                    <a:pt x="827" y="10475"/>
                  </a:cubicBezTo>
                  <a:cubicBezTo>
                    <a:pt x="0" y="10475"/>
                    <a:pt x="0" y="10475"/>
                    <a:pt x="0" y="10475"/>
                  </a:cubicBezTo>
                  <a:cubicBezTo>
                    <a:pt x="1662" y="10475"/>
                    <a:pt x="1118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9" name="Freeform 7"/>
            <p:cNvSpPr/>
            <p:nvPr/>
          </p:nvSpPr>
          <p:spPr>
            <a:xfrm>
              <a:off x="6283800" y="5573880"/>
              <a:ext cx="42480" cy="212400"/>
            </a:xfrm>
            <a:custGeom>
              <a:avLst/>
              <a:gdLst>
                <a:gd name="textAreaLeft" fmla="*/ 0 w 42480"/>
                <a:gd name="textAreaRight" fmla="*/ 42840 w 42480"/>
                <a:gd name="textAreaTop" fmla="*/ 0 h 212400"/>
                <a:gd name="textAreaBottom" fmla="*/ 212760 h 212400"/>
              </a:gdLst>
              <a:ahLst/>
              <a:rect l="textAreaLeft" t="textAreaTop" r="textAreaRight" b="textAreaBottom"/>
              <a:pathLst>
                <a:path w="3607" h="10475">
                  <a:moveTo>
                    <a:pt x="3607" y="10475"/>
                  </a:moveTo>
                  <a:cubicBezTo>
                    <a:pt x="1937" y="10475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475"/>
                    <a:pt x="2782" y="10475"/>
                  </a:cubicBezTo>
                  <a:lnTo>
                    <a:pt x="3607" y="10475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0" name="Freeform 11"/>
            <p:cNvSpPr/>
            <p:nvPr/>
          </p:nvSpPr>
          <p:spPr>
            <a:xfrm>
              <a:off x="6349320" y="5573880"/>
              <a:ext cx="42480" cy="210960"/>
            </a:xfrm>
            <a:custGeom>
              <a:avLst/>
              <a:gdLst>
                <a:gd name="textAreaLeft" fmla="*/ 0 w 42480"/>
                <a:gd name="textAreaRight" fmla="*/ 42840 w 42480"/>
                <a:gd name="textAreaTop" fmla="*/ 0 h 210960"/>
                <a:gd name="textAreaBottom" fmla="*/ 211320 h 210960"/>
              </a:gdLst>
              <a:ahLst/>
              <a:rect l="textAreaLeft" t="textAreaTop" r="textAreaRight" b="textAreaBottom"/>
              <a:pathLst>
                <a:path w="3607" h="10475">
                  <a:moveTo>
                    <a:pt x="3607" y="10475"/>
                  </a:moveTo>
                  <a:cubicBezTo>
                    <a:pt x="1937" y="10475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475"/>
                    <a:pt x="2782" y="10475"/>
                  </a:cubicBezTo>
                  <a:lnTo>
                    <a:pt x="3607" y="10475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1" name="Freeform 8"/>
            <p:cNvSpPr/>
            <p:nvPr/>
          </p:nvSpPr>
          <p:spPr>
            <a:xfrm>
              <a:off x="6250680" y="5573880"/>
              <a:ext cx="42480" cy="212400"/>
            </a:xfrm>
            <a:custGeom>
              <a:avLst/>
              <a:gdLst>
                <a:gd name="textAreaLeft" fmla="*/ 0 w 42480"/>
                <a:gd name="textAreaRight" fmla="*/ 42840 w 42480"/>
                <a:gd name="textAreaTop" fmla="*/ 0 h 212400"/>
                <a:gd name="textAreaBottom" fmla="*/ 212760 h 212400"/>
              </a:gdLst>
              <a:ahLst/>
              <a:rect l="textAreaLeft" t="textAreaTop" r="textAreaRight" b="textAreaBottom"/>
              <a:pathLst>
                <a:path w="3607" h="10500">
                  <a:moveTo>
                    <a:pt x="3607" y="10500"/>
                  </a:moveTo>
                  <a:cubicBezTo>
                    <a:pt x="1937" y="10500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500"/>
                    <a:pt x="2782" y="10500"/>
                  </a:cubicBezTo>
                  <a:lnTo>
                    <a:pt x="3607" y="1050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2" name="Freeform 12"/>
            <p:cNvSpPr/>
            <p:nvPr/>
          </p:nvSpPr>
          <p:spPr>
            <a:xfrm>
              <a:off x="6315840" y="5573880"/>
              <a:ext cx="42480" cy="212400"/>
            </a:xfrm>
            <a:custGeom>
              <a:avLst/>
              <a:gdLst>
                <a:gd name="textAreaLeft" fmla="*/ 0 w 42480"/>
                <a:gd name="textAreaRight" fmla="*/ 42840 w 42480"/>
                <a:gd name="textAreaTop" fmla="*/ 0 h 212400"/>
                <a:gd name="textAreaBottom" fmla="*/ 212760 h 212400"/>
              </a:gdLst>
              <a:ahLst/>
              <a:rect l="textAreaLeft" t="textAreaTop" r="textAreaRight" b="textAreaBottom"/>
              <a:pathLst>
                <a:path w="3607" h="10500">
                  <a:moveTo>
                    <a:pt x="3607" y="10500"/>
                  </a:moveTo>
                  <a:cubicBezTo>
                    <a:pt x="1937" y="10500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500"/>
                    <a:pt x="2782" y="10500"/>
                  </a:cubicBezTo>
                  <a:lnTo>
                    <a:pt x="3607" y="1050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3" name="Freeform 14"/>
            <p:cNvSpPr/>
            <p:nvPr/>
          </p:nvSpPr>
          <p:spPr>
            <a:xfrm>
              <a:off x="6445440" y="5573880"/>
              <a:ext cx="42480" cy="212400"/>
            </a:xfrm>
            <a:custGeom>
              <a:avLst/>
              <a:gdLst>
                <a:gd name="textAreaLeft" fmla="*/ 0 w 42480"/>
                <a:gd name="textAreaRight" fmla="*/ 42840 w 42480"/>
                <a:gd name="textAreaTop" fmla="*/ 0 h 212400"/>
                <a:gd name="textAreaBottom" fmla="*/ 212760 h 212400"/>
              </a:gdLst>
              <a:ahLst/>
              <a:rect l="textAreaLeft" t="textAreaTop" r="textAreaRight" b="textAreaBottom"/>
              <a:pathLst>
                <a:path w="3615" h="10500">
                  <a:moveTo>
                    <a:pt x="3615" y="0"/>
                  </a:moveTo>
                  <a:cubicBezTo>
                    <a:pt x="1942" y="0"/>
                    <a:pt x="2489" y="10500"/>
                    <a:pt x="827" y="10500"/>
                  </a:cubicBezTo>
                  <a:cubicBezTo>
                    <a:pt x="0" y="10500"/>
                    <a:pt x="0" y="10500"/>
                    <a:pt x="0" y="10500"/>
                  </a:cubicBezTo>
                  <a:cubicBezTo>
                    <a:pt x="1662" y="10500"/>
                    <a:pt x="1117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4" name="Freeform 10"/>
            <p:cNvSpPr/>
            <p:nvPr/>
          </p:nvSpPr>
          <p:spPr>
            <a:xfrm>
              <a:off x="6379920" y="5573880"/>
              <a:ext cx="42480" cy="212400"/>
            </a:xfrm>
            <a:custGeom>
              <a:avLst/>
              <a:gdLst>
                <a:gd name="textAreaLeft" fmla="*/ 0 w 42480"/>
                <a:gd name="textAreaRight" fmla="*/ 42840 w 42480"/>
                <a:gd name="textAreaTop" fmla="*/ 0 h 212400"/>
                <a:gd name="textAreaBottom" fmla="*/ 212760 h 212400"/>
              </a:gdLst>
              <a:ahLst/>
              <a:rect l="textAreaLeft" t="textAreaTop" r="textAreaRight" b="textAreaBottom"/>
              <a:pathLst>
                <a:path w="3615" h="10500">
                  <a:moveTo>
                    <a:pt x="3615" y="0"/>
                  </a:moveTo>
                  <a:cubicBezTo>
                    <a:pt x="1941" y="0"/>
                    <a:pt x="2489" y="10500"/>
                    <a:pt x="827" y="10500"/>
                  </a:cubicBezTo>
                  <a:cubicBezTo>
                    <a:pt x="0" y="10500"/>
                    <a:pt x="0" y="10500"/>
                    <a:pt x="0" y="10500"/>
                  </a:cubicBezTo>
                  <a:cubicBezTo>
                    <a:pt x="1662" y="10500"/>
                    <a:pt x="1117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5" name="Freeform 13"/>
            <p:cNvSpPr/>
            <p:nvPr/>
          </p:nvSpPr>
          <p:spPr>
            <a:xfrm>
              <a:off x="6478560" y="5574960"/>
              <a:ext cx="42480" cy="211320"/>
            </a:xfrm>
            <a:custGeom>
              <a:avLst/>
              <a:gdLst>
                <a:gd name="textAreaLeft" fmla="*/ 0 w 42480"/>
                <a:gd name="textAreaRight" fmla="*/ 42840 w 42480"/>
                <a:gd name="textAreaTop" fmla="*/ 0 h 211320"/>
                <a:gd name="textAreaBottom" fmla="*/ 211680 h 211320"/>
              </a:gdLst>
              <a:ahLst/>
              <a:rect l="textAreaLeft" t="textAreaTop" r="textAreaRight" b="textAreaBottom"/>
              <a:pathLst>
                <a:path w="3615" h="10475">
                  <a:moveTo>
                    <a:pt x="3615" y="0"/>
                  </a:moveTo>
                  <a:cubicBezTo>
                    <a:pt x="1942" y="0"/>
                    <a:pt x="2490" y="10475"/>
                    <a:pt x="827" y="10475"/>
                  </a:cubicBezTo>
                  <a:cubicBezTo>
                    <a:pt x="0" y="10475"/>
                    <a:pt x="0" y="10475"/>
                    <a:pt x="0" y="10475"/>
                  </a:cubicBezTo>
                  <a:cubicBezTo>
                    <a:pt x="1663" y="10475"/>
                    <a:pt x="1118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6" name="Freeform 9"/>
            <p:cNvSpPr/>
            <p:nvPr/>
          </p:nvSpPr>
          <p:spPr>
            <a:xfrm>
              <a:off x="6413040" y="5574960"/>
              <a:ext cx="42480" cy="211320"/>
            </a:xfrm>
            <a:custGeom>
              <a:avLst/>
              <a:gdLst>
                <a:gd name="textAreaLeft" fmla="*/ 0 w 42480"/>
                <a:gd name="textAreaRight" fmla="*/ 42840 w 42480"/>
                <a:gd name="textAreaTop" fmla="*/ 0 h 211320"/>
                <a:gd name="textAreaBottom" fmla="*/ 211680 h 211320"/>
              </a:gdLst>
              <a:ahLst/>
              <a:rect l="textAreaLeft" t="textAreaTop" r="textAreaRight" b="textAreaBottom"/>
              <a:pathLst>
                <a:path w="3615" h="10475">
                  <a:moveTo>
                    <a:pt x="3615" y="0"/>
                  </a:moveTo>
                  <a:cubicBezTo>
                    <a:pt x="1942" y="0"/>
                    <a:pt x="2489" y="10475"/>
                    <a:pt x="827" y="10475"/>
                  </a:cubicBezTo>
                  <a:cubicBezTo>
                    <a:pt x="0" y="10475"/>
                    <a:pt x="0" y="10475"/>
                    <a:pt x="0" y="10475"/>
                  </a:cubicBezTo>
                  <a:cubicBezTo>
                    <a:pt x="1662" y="10475"/>
                    <a:pt x="1118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7" name="Freeform 7"/>
            <p:cNvSpPr/>
            <p:nvPr/>
          </p:nvSpPr>
          <p:spPr>
            <a:xfrm>
              <a:off x="6413040" y="5573880"/>
              <a:ext cx="42480" cy="212400"/>
            </a:xfrm>
            <a:custGeom>
              <a:avLst/>
              <a:gdLst>
                <a:gd name="textAreaLeft" fmla="*/ 0 w 42480"/>
                <a:gd name="textAreaRight" fmla="*/ 42840 w 42480"/>
                <a:gd name="textAreaTop" fmla="*/ 0 h 212400"/>
                <a:gd name="textAreaBottom" fmla="*/ 212760 h 212400"/>
              </a:gdLst>
              <a:ahLst/>
              <a:rect l="textAreaLeft" t="textAreaTop" r="textAreaRight" b="textAreaBottom"/>
              <a:pathLst>
                <a:path w="3607" h="10475">
                  <a:moveTo>
                    <a:pt x="3607" y="10475"/>
                  </a:moveTo>
                  <a:cubicBezTo>
                    <a:pt x="1937" y="10475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475"/>
                    <a:pt x="2782" y="10475"/>
                  </a:cubicBezTo>
                  <a:lnTo>
                    <a:pt x="3607" y="10475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8" name="Freeform 11"/>
            <p:cNvSpPr/>
            <p:nvPr/>
          </p:nvSpPr>
          <p:spPr>
            <a:xfrm>
              <a:off x="6478560" y="5573880"/>
              <a:ext cx="42480" cy="210960"/>
            </a:xfrm>
            <a:custGeom>
              <a:avLst/>
              <a:gdLst>
                <a:gd name="textAreaLeft" fmla="*/ 0 w 42480"/>
                <a:gd name="textAreaRight" fmla="*/ 42840 w 42480"/>
                <a:gd name="textAreaTop" fmla="*/ 0 h 210960"/>
                <a:gd name="textAreaBottom" fmla="*/ 211320 h 210960"/>
              </a:gdLst>
              <a:ahLst/>
              <a:rect l="textAreaLeft" t="textAreaTop" r="textAreaRight" b="textAreaBottom"/>
              <a:pathLst>
                <a:path w="3607" h="10475">
                  <a:moveTo>
                    <a:pt x="3607" y="10475"/>
                  </a:moveTo>
                  <a:cubicBezTo>
                    <a:pt x="1937" y="10475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475"/>
                    <a:pt x="2782" y="10475"/>
                  </a:cubicBezTo>
                  <a:lnTo>
                    <a:pt x="3607" y="10475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9" name="Freeform 8"/>
            <p:cNvSpPr/>
            <p:nvPr/>
          </p:nvSpPr>
          <p:spPr>
            <a:xfrm>
              <a:off x="6379920" y="5573880"/>
              <a:ext cx="42480" cy="212400"/>
            </a:xfrm>
            <a:custGeom>
              <a:avLst/>
              <a:gdLst>
                <a:gd name="textAreaLeft" fmla="*/ 0 w 42480"/>
                <a:gd name="textAreaRight" fmla="*/ 42840 w 42480"/>
                <a:gd name="textAreaTop" fmla="*/ 0 h 212400"/>
                <a:gd name="textAreaBottom" fmla="*/ 212760 h 212400"/>
              </a:gdLst>
              <a:ahLst/>
              <a:rect l="textAreaLeft" t="textAreaTop" r="textAreaRight" b="textAreaBottom"/>
              <a:pathLst>
                <a:path w="3607" h="10500">
                  <a:moveTo>
                    <a:pt x="3607" y="10500"/>
                  </a:moveTo>
                  <a:cubicBezTo>
                    <a:pt x="1937" y="10500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500"/>
                    <a:pt x="2782" y="10500"/>
                  </a:cubicBezTo>
                  <a:lnTo>
                    <a:pt x="3607" y="1050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0" name="Freeform 12"/>
            <p:cNvSpPr/>
            <p:nvPr/>
          </p:nvSpPr>
          <p:spPr>
            <a:xfrm>
              <a:off x="6445440" y="5573880"/>
              <a:ext cx="42480" cy="212400"/>
            </a:xfrm>
            <a:custGeom>
              <a:avLst/>
              <a:gdLst>
                <a:gd name="textAreaLeft" fmla="*/ 0 w 42480"/>
                <a:gd name="textAreaRight" fmla="*/ 42840 w 42480"/>
                <a:gd name="textAreaTop" fmla="*/ 0 h 212400"/>
                <a:gd name="textAreaBottom" fmla="*/ 212760 h 212400"/>
              </a:gdLst>
              <a:ahLst/>
              <a:rect l="textAreaLeft" t="textAreaTop" r="textAreaRight" b="textAreaBottom"/>
              <a:pathLst>
                <a:path w="3607" h="10500">
                  <a:moveTo>
                    <a:pt x="3607" y="10500"/>
                  </a:moveTo>
                  <a:cubicBezTo>
                    <a:pt x="1937" y="10500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500"/>
                    <a:pt x="2782" y="10500"/>
                  </a:cubicBezTo>
                  <a:lnTo>
                    <a:pt x="3607" y="1050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1" name="Freeform 14"/>
            <p:cNvSpPr/>
            <p:nvPr/>
          </p:nvSpPr>
          <p:spPr>
            <a:xfrm>
              <a:off x="6574680" y="5573880"/>
              <a:ext cx="42480" cy="212400"/>
            </a:xfrm>
            <a:custGeom>
              <a:avLst/>
              <a:gdLst>
                <a:gd name="textAreaLeft" fmla="*/ 0 w 42480"/>
                <a:gd name="textAreaRight" fmla="*/ 42840 w 42480"/>
                <a:gd name="textAreaTop" fmla="*/ 0 h 212400"/>
                <a:gd name="textAreaBottom" fmla="*/ 212760 h 212400"/>
              </a:gdLst>
              <a:ahLst/>
              <a:rect l="textAreaLeft" t="textAreaTop" r="textAreaRight" b="textAreaBottom"/>
              <a:pathLst>
                <a:path w="3615" h="10500">
                  <a:moveTo>
                    <a:pt x="3615" y="0"/>
                  </a:moveTo>
                  <a:cubicBezTo>
                    <a:pt x="1942" y="0"/>
                    <a:pt x="2489" y="10500"/>
                    <a:pt x="827" y="10500"/>
                  </a:cubicBezTo>
                  <a:cubicBezTo>
                    <a:pt x="0" y="10500"/>
                    <a:pt x="0" y="10500"/>
                    <a:pt x="0" y="10500"/>
                  </a:cubicBezTo>
                  <a:cubicBezTo>
                    <a:pt x="1662" y="10500"/>
                    <a:pt x="1117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2" name="Freeform 10"/>
            <p:cNvSpPr/>
            <p:nvPr/>
          </p:nvSpPr>
          <p:spPr>
            <a:xfrm>
              <a:off x="6509160" y="5573880"/>
              <a:ext cx="42480" cy="212400"/>
            </a:xfrm>
            <a:custGeom>
              <a:avLst/>
              <a:gdLst>
                <a:gd name="textAreaLeft" fmla="*/ 0 w 42480"/>
                <a:gd name="textAreaRight" fmla="*/ 42840 w 42480"/>
                <a:gd name="textAreaTop" fmla="*/ 0 h 212400"/>
                <a:gd name="textAreaBottom" fmla="*/ 212760 h 212400"/>
              </a:gdLst>
              <a:ahLst/>
              <a:rect l="textAreaLeft" t="textAreaTop" r="textAreaRight" b="textAreaBottom"/>
              <a:pathLst>
                <a:path w="3615" h="10500">
                  <a:moveTo>
                    <a:pt x="3615" y="0"/>
                  </a:moveTo>
                  <a:cubicBezTo>
                    <a:pt x="1941" y="0"/>
                    <a:pt x="2489" y="10500"/>
                    <a:pt x="827" y="10500"/>
                  </a:cubicBezTo>
                  <a:cubicBezTo>
                    <a:pt x="0" y="10500"/>
                    <a:pt x="0" y="10500"/>
                    <a:pt x="0" y="10500"/>
                  </a:cubicBezTo>
                  <a:cubicBezTo>
                    <a:pt x="1662" y="10500"/>
                    <a:pt x="1117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3" name="Freeform 13"/>
            <p:cNvSpPr/>
            <p:nvPr/>
          </p:nvSpPr>
          <p:spPr>
            <a:xfrm>
              <a:off x="6607800" y="5574960"/>
              <a:ext cx="42480" cy="211320"/>
            </a:xfrm>
            <a:custGeom>
              <a:avLst/>
              <a:gdLst>
                <a:gd name="textAreaLeft" fmla="*/ 0 w 42480"/>
                <a:gd name="textAreaRight" fmla="*/ 42840 w 42480"/>
                <a:gd name="textAreaTop" fmla="*/ 0 h 211320"/>
                <a:gd name="textAreaBottom" fmla="*/ 211680 h 211320"/>
              </a:gdLst>
              <a:ahLst/>
              <a:rect l="textAreaLeft" t="textAreaTop" r="textAreaRight" b="textAreaBottom"/>
              <a:pathLst>
                <a:path w="3615" h="10475">
                  <a:moveTo>
                    <a:pt x="3615" y="0"/>
                  </a:moveTo>
                  <a:cubicBezTo>
                    <a:pt x="1942" y="0"/>
                    <a:pt x="2490" y="10475"/>
                    <a:pt x="827" y="10475"/>
                  </a:cubicBezTo>
                  <a:cubicBezTo>
                    <a:pt x="0" y="10475"/>
                    <a:pt x="0" y="10475"/>
                    <a:pt x="0" y="10475"/>
                  </a:cubicBezTo>
                  <a:cubicBezTo>
                    <a:pt x="1663" y="10475"/>
                    <a:pt x="1118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4" name="Freeform 9"/>
            <p:cNvSpPr/>
            <p:nvPr/>
          </p:nvSpPr>
          <p:spPr>
            <a:xfrm>
              <a:off x="6542280" y="5574960"/>
              <a:ext cx="42480" cy="211320"/>
            </a:xfrm>
            <a:custGeom>
              <a:avLst/>
              <a:gdLst>
                <a:gd name="textAreaLeft" fmla="*/ 0 w 42480"/>
                <a:gd name="textAreaRight" fmla="*/ 42840 w 42480"/>
                <a:gd name="textAreaTop" fmla="*/ 0 h 211320"/>
                <a:gd name="textAreaBottom" fmla="*/ 211680 h 211320"/>
              </a:gdLst>
              <a:ahLst/>
              <a:rect l="textAreaLeft" t="textAreaTop" r="textAreaRight" b="textAreaBottom"/>
              <a:pathLst>
                <a:path w="3615" h="10475">
                  <a:moveTo>
                    <a:pt x="3615" y="0"/>
                  </a:moveTo>
                  <a:cubicBezTo>
                    <a:pt x="1942" y="0"/>
                    <a:pt x="2489" y="10475"/>
                    <a:pt x="827" y="10475"/>
                  </a:cubicBezTo>
                  <a:cubicBezTo>
                    <a:pt x="0" y="10475"/>
                    <a:pt x="0" y="10475"/>
                    <a:pt x="0" y="10475"/>
                  </a:cubicBezTo>
                  <a:cubicBezTo>
                    <a:pt x="1662" y="10475"/>
                    <a:pt x="1118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5" name="Freeform 7"/>
            <p:cNvSpPr/>
            <p:nvPr/>
          </p:nvSpPr>
          <p:spPr>
            <a:xfrm>
              <a:off x="6542280" y="5573880"/>
              <a:ext cx="42480" cy="212400"/>
            </a:xfrm>
            <a:custGeom>
              <a:avLst/>
              <a:gdLst>
                <a:gd name="textAreaLeft" fmla="*/ 0 w 42480"/>
                <a:gd name="textAreaRight" fmla="*/ 42840 w 42480"/>
                <a:gd name="textAreaTop" fmla="*/ 0 h 212400"/>
                <a:gd name="textAreaBottom" fmla="*/ 212760 h 212400"/>
              </a:gdLst>
              <a:ahLst/>
              <a:rect l="textAreaLeft" t="textAreaTop" r="textAreaRight" b="textAreaBottom"/>
              <a:pathLst>
                <a:path w="3607" h="10475">
                  <a:moveTo>
                    <a:pt x="3607" y="10475"/>
                  </a:moveTo>
                  <a:cubicBezTo>
                    <a:pt x="1937" y="10475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475"/>
                    <a:pt x="2782" y="10475"/>
                  </a:cubicBezTo>
                  <a:lnTo>
                    <a:pt x="3607" y="10475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6" name="Freeform 11"/>
            <p:cNvSpPr/>
            <p:nvPr/>
          </p:nvSpPr>
          <p:spPr>
            <a:xfrm>
              <a:off x="6607800" y="5573880"/>
              <a:ext cx="42480" cy="210960"/>
            </a:xfrm>
            <a:custGeom>
              <a:avLst/>
              <a:gdLst>
                <a:gd name="textAreaLeft" fmla="*/ 0 w 42480"/>
                <a:gd name="textAreaRight" fmla="*/ 42840 w 42480"/>
                <a:gd name="textAreaTop" fmla="*/ 0 h 210960"/>
                <a:gd name="textAreaBottom" fmla="*/ 211320 h 210960"/>
              </a:gdLst>
              <a:ahLst/>
              <a:rect l="textAreaLeft" t="textAreaTop" r="textAreaRight" b="textAreaBottom"/>
              <a:pathLst>
                <a:path w="3607" h="10475">
                  <a:moveTo>
                    <a:pt x="3607" y="10475"/>
                  </a:moveTo>
                  <a:cubicBezTo>
                    <a:pt x="1937" y="10475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475"/>
                    <a:pt x="2782" y="10475"/>
                  </a:cubicBezTo>
                  <a:lnTo>
                    <a:pt x="3607" y="10475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7" name="Freeform 8"/>
            <p:cNvSpPr/>
            <p:nvPr/>
          </p:nvSpPr>
          <p:spPr>
            <a:xfrm>
              <a:off x="6509160" y="5573880"/>
              <a:ext cx="42480" cy="212400"/>
            </a:xfrm>
            <a:custGeom>
              <a:avLst/>
              <a:gdLst>
                <a:gd name="textAreaLeft" fmla="*/ 0 w 42480"/>
                <a:gd name="textAreaRight" fmla="*/ 42840 w 42480"/>
                <a:gd name="textAreaTop" fmla="*/ 0 h 212400"/>
                <a:gd name="textAreaBottom" fmla="*/ 212760 h 212400"/>
              </a:gdLst>
              <a:ahLst/>
              <a:rect l="textAreaLeft" t="textAreaTop" r="textAreaRight" b="textAreaBottom"/>
              <a:pathLst>
                <a:path w="3607" h="10500">
                  <a:moveTo>
                    <a:pt x="3607" y="10500"/>
                  </a:moveTo>
                  <a:cubicBezTo>
                    <a:pt x="1937" y="10500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500"/>
                    <a:pt x="2782" y="10500"/>
                  </a:cubicBezTo>
                  <a:lnTo>
                    <a:pt x="3607" y="1050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8" name="Freeform 12"/>
            <p:cNvSpPr/>
            <p:nvPr/>
          </p:nvSpPr>
          <p:spPr>
            <a:xfrm>
              <a:off x="6574680" y="5573880"/>
              <a:ext cx="42480" cy="212400"/>
            </a:xfrm>
            <a:custGeom>
              <a:avLst/>
              <a:gdLst>
                <a:gd name="textAreaLeft" fmla="*/ 0 w 42480"/>
                <a:gd name="textAreaRight" fmla="*/ 42840 w 42480"/>
                <a:gd name="textAreaTop" fmla="*/ 0 h 212400"/>
                <a:gd name="textAreaBottom" fmla="*/ 212760 h 212400"/>
              </a:gdLst>
              <a:ahLst/>
              <a:rect l="textAreaLeft" t="textAreaTop" r="textAreaRight" b="textAreaBottom"/>
              <a:pathLst>
                <a:path w="3607" h="10500">
                  <a:moveTo>
                    <a:pt x="3607" y="10500"/>
                  </a:moveTo>
                  <a:cubicBezTo>
                    <a:pt x="1937" y="10500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500"/>
                    <a:pt x="2782" y="10500"/>
                  </a:cubicBezTo>
                  <a:lnTo>
                    <a:pt x="3607" y="1050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9" name="Freeform 14"/>
            <p:cNvSpPr/>
            <p:nvPr/>
          </p:nvSpPr>
          <p:spPr>
            <a:xfrm>
              <a:off x="6703920" y="5573880"/>
              <a:ext cx="42480" cy="212400"/>
            </a:xfrm>
            <a:custGeom>
              <a:avLst/>
              <a:gdLst>
                <a:gd name="textAreaLeft" fmla="*/ 0 w 42480"/>
                <a:gd name="textAreaRight" fmla="*/ 42840 w 42480"/>
                <a:gd name="textAreaTop" fmla="*/ 0 h 212400"/>
                <a:gd name="textAreaBottom" fmla="*/ 212760 h 212400"/>
              </a:gdLst>
              <a:ahLst/>
              <a:rect l="textAreaLeft" t="textAreaTop" r="textAreaRight" b="textAreaBottom"/>
              <a:pathLst>
                <a:path w="3615" h="10500">
                  <a:moveTo>
                    <a:pt x="3615" y="0"/>
                  </a:moveTo>
                  <a:cubicBezTo>
                    <a:pt x="1942" y="0"/>
                    <a:pt x="2489" y="10500"/>
                    <a:pt x="827" y="10500"/>
                  </a:cubicBezTo>
                  <a:cubicBezTo>
                    <a:pt x="0" y="10500"/>
                    <a:pt x="0" y="10500"/>
                    <a:pt x="0" y="10500"/>
                  </a:cubicBezTo>
                  <a:cubicBezTo>
                    <a:pt x="1662" y="10500"/>
                    <a:pt x="1117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0" name="Freeform 10"/>
            <p:cNvSpPr/>
            <p:nvPr/>
          </p:nvSpPr>
          <p:spPr>
            <a:xfrm>
              <a:off x="6638760" y="5573880"/>
              <a:ext cx="42480" cy="212400"/>
            </a:xfrm>
            <a:custGeom>
              <a:avLst/>
              <a:gdLst>
                <a:gd name="textAreaLeft" fmla="*/ 0 w 42480"/>
                <a:gd name="textAreaRight" fmla="*/ 42840 w 42480"/>
                <a:gd name="textAreaTop" fmla="*/ 0 h 212400"/>
                <a:gd name="textAreaBottom" fmla="*/ 212760 h 212400"/>
              </a:gdLst>
              <a:ahLst/>
              <a:rect l="textAreaLeft" t="textAreaTop" r="textAreaRight" b="textAreaBottom"/>
              <a:pathLst>
                <a:path w="3615" h="10500">
                  <a:moveTo>
                    <a:pt x="3615" y="0"/>
                  </a:moveTo>
                  <a:cubicBezTo>
                    <a:pt x="1941" y="0"/>
                    <a:pt x="2489" y="10500"/>
                    <a:pt x="827" y="10500"/>
                  </a:cubicBezTo>
                  <a:cubicBezTo>
                    <a:pt x="0" y="10500"/>
                    <a:pt x="0" y="10500"/>
                    <a:pt x="0" y="10500"/>
                  </a:cubicBezTo>
                  <a:cubicBezTo>
                    <a:pt x="1662" y="10500"/>
                    <a:pt x="1117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1" name="Freeform 13"/>
            <p:cNvSpPr/>
            <p:nvPr/>
          </p:nvSpPr>
          <p:spPr>
            <a:xfrm>
              <a:off x="6737040" y="5574960"/>
              <a:ext cx="42480" cy="211320"/>
            </a:xfrm>
            <a:custGeom>
              <a:avLst/>
              <a:gdLst>
                <a:gd name="textAreaLeft" fmla="*/ 0 w 42480"/>
                <a:gd name="textAreaRight" fmla="*/ 42840 w 42480"/>
                <a:gd name="textAreaTop" fmla="*/ 0 h 211320"/>
                <a:gd name="textAreaBottom" fmla="*/ 211680 h 211320"/>
              </a:gdLst>
              <a:ahLst/>
              <a:rect l="textAreaLeft" t="textAreaTop" r="textAreaRight" b="textAreaBottom"/>
              <a:pathLst>
                <a:path w="3615" h="10475">
                  <a:moveTo>
                    <a:pt x="3615" y="0"/>
                  </a:moveTo>
                  <a:cubicBezTo>
                    <a:pt x="1942" y="0"/>
                    <a:pt x="2490" y="10475"/>
                    <a:pt x="827" y="10475"/>
                  </a:cubicBezTo>
                  <a:cubicBezTo>
                    <a:pt x="0" y="10475"/>
                    <a:pt x="0" y="10475"/>
                    <a:pt x="0" y="10475"/>
                  </a:cubicBezTo>
                  <a:cubicBezTo>
                    <a:pt x="1663" y="10475"/>
                    <a:pt x="1118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2" name="Freeform 9"/>
            <p:cNvSpPr/>
            <p:nvPr/>
          </p:nvSpPr>
          <p:spPr>
            <a:xfrm>
              <a:off x="6671880" y="5574960"/>
              <a:ext cx="42480" cy="211320"/>
            </a:xfrm>
            <a:custGeom>
              <a:avLst/>
              <a:gdLst>
                <a:gd name="textAreaLeft" fmla="*/ 0 w 42480"/>
                <a:gd name="textAreaRight" fmla="*/ 42840 w 42480"/>
                <a:gd name="textAreaTop" fmla="*/ 0 h 211320"/>
                <a:gd name="textAreaBottom" fmla="*/ 211680 h 211320"/>
              </a:gdLst>
              <a:ahLst/>
              <a:rect l="textAreaLeft" t="textAreaTop" r="textAreaRight" b="textAreaBottom"/>
              <a:pathLst>
                <a:path w="3615" h="10475">
                  <a:moveTo>
                    <a:pt x="3615" y="0"/>
                  </a:moveTo>
                  <a:cubicBezTo>
                    <a:pt x="1942" y="0"/>
                    <a:pt x="2489" y="10475"/>
                    <a:pt x="827" y="10475"/>
                  </a:cubicBezTo>
                  <a:cubicBezTo>
                    <a:pt x="0" y="10475"/>
                    <a:pt x="0" y="10475"/>
                    <a:pt x="0" y="10475"/>
                  </a:cubicBezTo>
                  <a:cubicBezTo>
                    <a:pt x="1662" y="10475"/>
                    <a:pt x="1118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3" name="Freeform 7"/>
            <p:cNvSpPr/>
            <p:nvPr/>
          </p:nvSpPr>
          <p:spPr>
            <a:xfrm>
              <a:off x="6671880" y="5573880"/>
              <a:ext cx="42480" cy="212400"/>
            </a:xfrm>
            <a:custGeom>
              <a:avLst/>
              <a:gdLst>
                <a:gd name="textAreaLeft" fmla="*/ 0 w 42480"/>
                <a:gd name="textAreaRight" fmla="*/ 42840 w 42480"/>
                <a:gd name="textAreaTop" fmla="*/ 0 h 212400"/>
                <a:gd name="textAreaBottom" fmla="*/ 212760 h 212400"/>
              </a:gdLst>
              <a:ahLst/>
              <a:rect l="textAreaLeft" t="textAreaTop" r="textAreaRight" b="textAreaBottom"/>
              <a:pathLst>
                <a:path w="3607" h="10475">
                  <a:moveTo>
                    <a:pt x="3607" y="10475"/>
                  </a:moveTo>
                  <a:cubicBezTo>
                    <a:pt x="1937" y="10475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475"/>
                    <a:pt x="2782" y="10475"/>
                  </a:cubicBezTo>
                  <a:lnTo>
                    <a:pt x="3607" y="10475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4" name="Freeform 11"/>
            <p:cNvSpPr/>
            <p:nvPr/>
          </p:nvSpPr>
          <p:spPr>
            <a:xfrm>
              <a:off x="6737040" y="5573880"/>
              <a:ext cx="42480" cy="210960"/>
            </a:xfrm>
            <a:custGeom>
              <a:avLst/>
              <a:gdLst>
                <a:gd name="textAreaLeft" fmla="*/ 0 w 42480"/>
                <a:gd name="textAreaRight" fmla="*/ 42840 w 42480"/>
                <a:gd name="textAreaTop" fmla="*/ 0 h 210960"/>
                <a:gd name="textAreaBottom" fmla="*/ 211320 h 210960"/>
              </a:gdLst>
              <a:ahLst/>
              <a:rect l="textAreaLeft" t="textAreaTop" r="textAreaRight" b="textAreaBottom"/>
              <a:pathLst>
                <a:path w="3607" h="10475">
                  <a:moveTo>
                    <a:pt x="3607" y="10475"/>
                  </a:moveTo>
                  <a:cubicBezTo>
                    <a:pt x="1937" y="10475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475"/>
                    <a:pt x="2782" y="10475"/>
                  </a:cubicBezTo>
                  <a:lnTo>
                    <a:pt x="3607" y="10475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5" name="Freeform 8"/>
            <p:cNvSpPr/>
            <p:nvPr/>
          </p:nvSpPr>
          <p:spPr>
            <a:xfrm>
              <a:off x="6638760" y="5573880"/>
              <a:ext cx="42480" cy="212400"/>
            </a:xfrm>
            <a:custGeom>
              <a:avLst/>
              <a:gdLst>
                <a:gd name="textAreaLeft" fmla="*/ 0 w 42480"/>
                <a:gd name="textAreaRight" fmla="*/ 42840 w 42480"/>
                <a:gd name="textAreaTop" fmla="*/ 0 h 212400"/>
                <a:gd name="textAreaBottom" fmla="*/ 212760 h 212400"/>
              </a:gdLst>
              <a:ahLst/>
              <a:rect l="textAreaLeft" t="textAreaTop" r="textAreaRight" b="textAreaBottom"/>
              <a:pathLst>
                <a:path w="3607" h="10500">
                  <a:moveTo>
                    <a:pt x="3607" y="10500"/>
                  </a:moveTo>
                  <a:cubicBezTo>
                    <a:pt x="1937" y="10500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500"/>
                    <a:pt x="2782" y="10500"/>
                  </a:cubicBezTo>
                  <a:lnTo>
                    <a:pt x="3607" y="1050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6" name="Freeform 12"/>
            <p:cNvSpPr/>
            <p:nvPr/>
          </p:nvSpPr>
          <p:spPr>
            <a:xfrm>
              <a:off x="6703920" y="5573880"/>
              <a:ext cx="42480" cy="212400"/>
            </a:xfrm>
            <a:custGeom>
              <a:avLst/>
              <a:gdLst>
                <a:gd name="textAreaLeft" fmla="*/ 0 w 42480"/>
                <a:gd name="textAreaRight" fmla="*/ 42840 w 42480"/>
                <a:gd name="textAreaTop" fmla="*/ 0 h 212400"/>
                <a:gd name="textAreaBottom" fmla="*/ 212760 h 212400"/>
              </a:gdLst>
              <a:ahLst/>
              <a:rect l="textAreaLeft" t="textAreaTop" r="textAreaRight" b="textAreaBottom"/>
              <a:pathLst>
                <a:path w="3607" h="10500">
                  <a:moveTo>
                    <a:pt x="3607" y="10500"/>
                  </a:moveTo>
                  <a:cubicBezTo>
                    <a:pt x="1937" y="10500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500"/>
                    <a:pt x="2782" y="10500"/>
                  </a:cubicBezTo>
                  <a:lnTo>
                    <a:pt x="3607" y="1050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7" name="Freeform 14"/>
            <p:cNvSpPr/>
            <p:nvPr/>
          </p:nvSpPr>
          <p:spPr>
            <a:xfrm>
              <a:off x="6833520" y="5573880"/>
              <a:ext cx="42480" cy="212400"/>
            </a:xfrm>
            <a:custGeom>
              <a:avLst/>
              <a:gdLst>
                <a:gd name="textAreaLeft" fmla="*/ 0 w 42480"/>
                <a:gd name="textAreaRight" fmla="*/ 42840 w 42480"/>
                <a:gd name="textAreaTop" fmla="*/ 0 h 212400"/>
                <a:gd name="textAreaBottom" fmla="*/ 212760 h 212400"/>
              </a:gdLst>
              <a:ahLst/>
              <a:rect l="textAreaLeft" t="textAreaTop" r="textAreaRight" b="textAreaBottom"/>
              <a:pathLst>
                <a:path w="3615" h="10500">
                  <a:moveTo>
                    <a:pt x="3615" y="0"/>
                  </a:moveTo>
                  <a:cubicBezTo>
                    <a:pt x="1942" y="0"/>
                    <a:pt x="2489" y="10500"/>
                    <a:pt x="827" y="10500"/>
                  </a:cubicBezTo>
                  <a:cubicBezTo>
                    <a:pt x="0" y="10500"/>
                    <a:pt x="0" y="10500"/>
                    <a:pt x="0" y="10500"/>
                  </a:cubicBezTo>
                  <a:cubicBezTo>
                    <a:pt x="1662" y="10500"/>
                    <a:pt x="1117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8" name="Freeform 10"/>
            <p:cNvSpPr/>
            <p:nvPr/>
          </p:nvSpPr>
          <p:spPr>
            <a:xfrm>
              <a:off x="6768000" y="5573880"/>
              <a:ext cx="42480" cy="212400"/>
            </a:xfrm>
            <a:custGeom>
              <a:avLst/>
              <a:gdLst>
                <a:gd name="textAreaLeft" fmla="*/ 0 w 42480"/>
                <a:gd name="textAreaRight" fmla="*/ 42840 w 42480"/>
                <a:gd name="textAreaTop" fmla="*/ 0 h 212400"/>
                <a:gd name="textAreaBottom" fmla="*/ 212760 h 212400"/>
              </a:gdLst>
              <a:ahLst/>
              <a:rect l="textAreaLeft" t="textAreaTop" r="textAreaRight" b="textAreaBottom"/>
              <a:pathLst>
                <a:path w="3615" h="10500">
                  <a:moveTo>
                    <a:pt x="3615" y="0"/>
                  </a:moveTo>
                  <a:cubicBezTo>
                    <a:pt x="1941" y="0"/>
                    <a:pt x="2489" y="10500"/>
                    <a:pt x="827" y="10500"/>
                  </a:cubicBezTo>
                  <a:cubicBezTo>
                    <a:pt x="0" y="10500"/>
                    <a:pt x="0" y="10500"/>
                    <a:pt x="0" y="10500"/>
                  </a:cubicBezTo>
                  <a:cubicBezTo>
                    <a:pt x="1662" y="10500"/>
                    <a:pt x="1117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9" name="Freeform 13"/>
            <p:cNvSpPr/>
            <p:nvPr/>
          </p:nvSpPr>
          <p:spPr>
            <a:xfrm>
              <a:off x="6866280" y="5574960"/>
              <a:ext cx="42480" cy="211320"/>
            </a:xfrm>
            <a:custGeom>
              <a:avLst/>
              <a:gdLst>
                <a:gd name="textAreaLeft" fmla="*/ 0 w 42480"/>
                <a:gd name="textAreaRight" fmla="*/ 42840 w 42480"/>
                <a:gd name="textAreaTop" fmla="*/ 0 h 211320"/>
                <a:gd name="textAreaBottom" fmla="*/ 211680 h 211320"/>
              </a:gdLst>
              <a:ahLst/>
              <a:rect l="textAreaLeft" t="textAreaTop" r="textAreaRight" b="textAreaBottom"/>
              <a:pathLst>
                <a:path w="3615" h="10475">
                  <a:moveTo>
                    <a:pt x="3615" y="0"/>
                  </a:moveTo>
                  <a:cubicBezTo>
                    <a:pt x="1942" y="0"/>
                    <a:pt x="2490" y="10475"/>
                    <a:pt x="827" y="10475"/>
                  </a:cubicBezTo>
                  <a:cubicBezTo>
                    <a:pt x="0" y="10475"/>
                    <a:pt x="0" y="10475"/>
                    <a:pt x="0" y="10475"/>
                  </a:cubicBezTo>
                  <a:cubicBezTo>
                    <a:pt x="1663" y="10475"/>
                    <a:pt x="1118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0" name="Freeform 9"/>
            <p:cNvSpPr/>
            <p:nvPr/>
          </p:nvSpPr>
          <p:spPr>
            <a:xfrm>
              <a:off x="6801120" y="5574960"/>
              <a:ext cx="42480" cy="211320"/>
            </a:xfrm>
            <a:custGeom>
              <a:avLst/>
              <a:gdLst>
                <a:gd name="textAreaLeft" fmla="*/ 0 w 42480"/>
                <a:gd name="textAreaRight" fmla="*/ 42840 w 42480"/>
                <a:gd name="textAreaTop" fmla="*/ 0 h 211320"/>
                <a:gd name="textAreaBottom" fmla="*/ 211680 h 211320"/>
              </a:gdLst>
              <a:ahLst/>
              <a:rect l="textAreaLeft" t="textAreaTop" r="textAreaRight" b="textAreaBottom"/>
              <a:pathLst>
                <a:path w="3615" h="10475">
                  <a:moveTo>
                    <a:pt x="3615" y="0"/>
                  </a:moveTo>
                  <a:cubicBezTo>
                    <a:pt x="1942" y="0"/>
                    <a:pt x="2489" y="10475"/>
                    <a:pt x="827" y="10475"/>
                  </a:cubicBezTo>
                  <a:cubicBezTo>
                    <a:pt x="0" y="10475"/>
                    <a:pt x="0" y="10475"/>
                    <a:pt x="0" y="10475"/>
                  </a:cubicBezTo>
                  <a:cubicBezTo>
                    <a:pt x="1662" y="10475"/>
                    <a:pt x="1118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1" name="Freeform 7"/>
            <p:cNvSpPr/>
            <p:nvPr/>
          </p:nvSpPr>
          <p:spPr>
            <a:xfrm>
              <a:off x="6801120" y="5573880"/>
              <a:ext cx="42480" cy="212400"/>
            </a:xfrm>
            <a:custGeom>
              <a:avLst/>
              <a:gdLst>
                <a:gd name="textAreaLeft" fmla="*/ 0 w 42480"/>
                <a:gd name="textAreaRight" fmla="*/ 42840 w 42480"/>
                <a:gd name="textAreaTop" fmla="*/ 0 h 212400"/>
                <a:gd name="textAreaBottom" fmla="*/ 212760 h 212400"/>
              </a:gdLst>
              <a:ahLst/>
              <a:rect l="textAreaLeft" t="textAreaTop" r="textAreaRight" b="textAreaBottom"/>
              <a:pathLst>
                <a:path w="3607" h="10475">
                  <a:moveTo>
                    <a:pt x="3607" y="10475"/>
                  </a:moveTo>
                  <a:cubicBezTo>
                    <a:pt x="1937" y="10475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475"/>
                    <a:pt x="2782" y="10475"/>
                  </a:cubicBezTo>
                  <a:lnTo>
                    <a:pt x="3607" y="10475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2" name="Freeform 11"/>
            <p:cNvSpPr/>
            <p:nvPr/>
          </p:nvSpPr>
          <p:spPr>
            <a:xfrm>
              <a:off x="6866280" y="5573880"/>
              <a:ext cx="42480" cy="210960"/>
            </a:xfrm>
            <a:custGeom>
              <a:avLst/>
              <a:gdLst>
                <a:gd name="textAreaLeft" fmla="*/ 0 w 42480"/>
                <a:gd name="textAreaRight" fmla="*/ 42840 w 42480"/>
                <a:gd name="textAreaTop" fmla="*/ 0 h 210960"/>
                <a:gd name="textAreaBottom" fmla="*/ 211320 h 210960"/>
              </a:gdLst>
              <a:ahLst/>
              <a:rect l="textAreaLeft" t="textAreaTop" r="textAreaRight" b="textAreaBottom"/>
              <a:pathLst>
                <a:path w="3607" h="10475">
                  <a:moveTo>
                    <a:pt x="3607" y="10475"/>
                  </a:moveTo>
                  <a:cubicBezTo>
                    <a:pt x="1937" y="10475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475"/>
                    <a:pt x="2782" y="10475"/>
                  </a:cubicBezTo>
                  <a:lnTo>
                    <a:pt x="3607" y="10475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3" name="Freeform 8"/>
            <p:cNvSpPr/>
            <p:nvPr/>
          </p:nvSpPr>
          <p:spPr>
            <a:xfrm>
              <a:off x="6768000" y="5573880"/>
              <a:ext cx="42480" cy="212400"/>
            </a:xfrm>
            <a:custGeom>
              <a:avLst/>
              <a:gdLst>
                <a:gd name="textAreaLeft" fmla="*/ 0 w 42480"/>
                <a:gd name="textAreaRight" fmla="*/ 42840 w 42480"/>
                <a:gd name="textAreaTop" fmla="*/ 0 h 212400"/>
                <a:gd name="textAreaBottom" fmla="*/ 212760 h 212400"/>
              </a:gdLst>
              <a:ahLst/>
              <a:rect l="textAreaLeft" t="textAreaTop" r="textAreaRight" b="textAreaBottom"/>
              <a:pathLst>
                <a:path w="3607" h="10500">
                  <a:moveTo>
                    <a:pt x="3607" y="10500"/>
                  </a:moveTo>
                  <a:cubicBezTo>
                    <a:pt x="1937" y="10500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500"/>
                    <a:pt x="2782" y="10500"/>
                  </a:cubicBezTo>
                  <a:lnTo>
                    <a:pt x="3607" y="1050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4" name="Freeform 12"/>
            <p:cNvSpPr/>
            <p:nvPr/>
          </p:nvSpPr>
          <p:spPr>
            <a:xfrm>
              <a:off x="6833520" y="5573880"/>
              <a:ext cx="42480" cy="212400"/>
            </a:xfrm>
            <a:custGeom>
              <a:avLst/>
              <a:gdLst>
                <a:gd name="textAreaLeft" fmla="*/ 0 w 42480"/>
                <a:gd name="textAreaRight" fmla="*/ 42840 w 42480"/>
                <a:gd name="textAreaTop" fmla="*/ 0 h 212400"/>
                <a:gd name="textAreaBottom" fmla="*/ 212760 h 212400"/>
              </a:gdLst>
              <a:ahLst/>
              <a:rect l="textAreaLeft" t="textAreaTop" r="textAreaRight" b="textAreaBottom"/>
              <a:pathLst>
                <a:path w="3607" h="10500">
                  <a:moveTo>
                    <a:pt x="3607" y="10500"/>
                  </a:moveTo>
                  <a:cubicBezTo>
                    <a:pt x="1937" y="10500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500"/>
                    <a:pt x="2782" y="10500"/>
                  </a:cubicBezTo>
                  <a:lnTo>
                    <a:pt x="3607" y="1050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5" name="Freeform 14"/>
            <p:cNvSpPr/>
            <p:nvPr/>
          </p:nvSpPr>
          <p:spPr>
            <a:xfrm>
              <a:off x="6964920" y="5573880"/>
              <a:ext cx="42480" cy="212400"/>
            </a:xfrm>
            <a:custGeom>
              <a:avLst/>
              <a:gdLst>
                <a:gd name="textAreaLeft" fmla="*/ 0 w 42480"/>
                <a:gd name="textAreaRight" fmla="*/ 42840 w 42480"/>
                <a:gd name="textAreaTop" fmla="*/ 0 h 212400"/>
                <a:gd name="textAreaBottom" fmla="*/ 212760 h 212400"/>
              </a:gdLst>
              <a:ahLst/>
              <a:rect l="textAreaLeft" t="textAreaTop" r="textAreaRight" b="textAreaBottom"/>
              <a:pathLst>
                <a:path w="3615" h="10500">
                  <a:moveTo>
                    <a:pt x="3615" y="0"/>
                  </a:moveTo>
                  <a:cubicBezTo>
                    <a:pt x="1942" y="0"/>
                    <a:pt x="2489" y="10500"/>
                    <a:pt x="827" y="10500"/>
                  </a:cubicBezTo>
                  <a:cubicBezTo>
                    <a:pt x="0" y="10500"/>
                    <a:pt x="0" y="10500"/>
                    <a:pt x="0" y="10500"/>
                  </a:cubicBezTo>
                  <a:cubicBezTo>
                    <a:pt x="1662" y="10500"/>
                    <a:pt x="1117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6" name="Freeform 10"/>
            <p:cNvSpPr/>
            <p:nvPr/>
          </p:nvSpPr>
          <p:spPr>
            <a:xfrm>
              <a:off x="6899400" y="5573880"/>
              <a:ext cx="42480" cy="212400"/>
            </a:xfrm>
            <a:custGeom>
              <a:avLst/>
              <a:gdLst>
                <a:gd name="textAreaLeft" fmla="*/ 0 w 42480"/>
                <a:gd name="textAreaRight" fmla="*/ 42840 w 42480"/>
                <a:gd name="textAreaTop" fmla="*/ 0 h 212400"/>
                <a:gd name="textAreaBottom" fmla="*/ 212760 h 212400"/>
              </a:gdLst>
              <a:ahLst/>
              <a:rect l="textAreaLeft" t="textAreaTop" r="textAreaRight" b="textAreaBottom"/>
              <a:pathLst>
                <a:path w="3615" h="10500">
                  <a:moveTo>
                    <a:pt x="3615" y="0"/>
                  </a:moveTo>
                  <a:cubicBezTo>
                    <a:pt x="1941" y="0"/>
                    <a:pt x="2489" y="10500"/>
                    <a:pt x="827" y="10500"/>
                  </a:cubicBezTo>
                  <a:cubicBezTo>
                    <a:pt x="0" y="10500"/>
                    <a:pt x="0" y="10500"/>
                    <a:pt x="0" y="10500"/>
                  </a:cubicBezTo>
                  <a:cubicBezTo>
                    <a:pt x="1662" y="10500"/>
                    <a:pt x="1117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7" name="Freeform 13"/>
            <p:cNvSpPr/>
            <p:nvPr/>
          </p:nvSpPr>
          <p:spPr>
            <a:xfrm>
              <a:off x="6998040" y="5574960"/>
              <a:ext cx="42480" cy="211320"/>
            </a:xfrm>
            <a:custGeom>
              <a:avLst/>
              <a:gdLst>
                <a:gd name="textAreaLeft" fmla="*/ 0 w 42480"/>
                <a:gd name="textAreaRight" fmla="*/ 42840 w 42480"/>
                <a:gd name="textAreaTop" fmla="*/ 0 h 211320"/>
                <a:gd name="textAreaBottom" fmla="*/ 211680 h 211320"/>
              </a:gdLst>
              <a:ahLst/>
              <a:rect l="textAreaLeft" t="textAreaTop" r="textAreaRight" b="textAreaBottom"/>
              <a:pathLst>
                <a:path w="3615" h="10475">
                  <a:moveTo>
                    <a:pt x="3615" y="0"/>
                  </a:moveTo>
                  <a:cubicBezTo>
                    <a:pt x="1942" y="0"/>
                    <a:pt x="2490" y="10475"/>
                    <a:pt x="827" y="10475"/>
                  </a:cubicBezTo>
                  <a:cubicBezTo>
                    <a:pt x="0" y="10475"/>
                    <a:pt x="0" y="10475"/>
                    <a:pt x="0" y="10475"/>
                  </a:cubicBezTo>
                  <a:cubicBezTo>
                    <a:pt x="1663" y="10475"/>
                    <a:pt x="1118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8" name="Freeform 9"/>
            <p:cNvSpPr/>
            <p:nvPr/>
          </p:nvSpPr>
          <p:spPr>
            <a:xfrm>
              <a:off x="6932520" y="5574960"/>
              <a:ext cx="42480" cy="211320"/>
            </a:xfrm>
            <a:custGeom>
              <a:avLst/>
              <a:gdLst>
                <a:gd name="textAreaLeft" fmla="*/ 0 w 42480"/>
                <a:gd name="textAreaRight" fmla="*/ 42840 w 42480"/>
                <a:gd name="textAreaTop" fmla="*/ 0 h 211320"/>
                <a:gd name="textAreaBottom" fmla="*/ 211680 h 211320"/>
              </a:gdLst>
              <a:ahLst/>
              <a:rect l="textAreaLeft" t="textAreaTop" r="textAreaRight" b="textAreaBottom"/>
              <a:pathLst>
                <a:path w="3615" h="10475">
                  <a:moveTo>
                    <a:pt x="3615" y="0"/>
                  </a:moveTo>
                  <a:cubicBezTo>
                    <a:pt x="1942" y="0"/>
                    <a:pt x="2489" y="10475"/>
                    <a:pt x="827" y="10475"/>
                  </a:cubicBezTo>
                  <a:cubicBezTo>
                    <a:pt x="0" y="10475"/>
                    <a:pt x="0" y="10475"/>
                    <a:pt x="0" y="10475"/>
                  </a:cubicBezTo>
                  <a:cubicBezTo>
                    <a:pt x="1662" y="10475"/>
                    <a:pt x="1118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9" name="Freeform 7"/>
            <p:cNvSpPr/>
            <p:nvPr/>
          </p:nvSpPr>
          <p:spPr>
            <a:xfrm>
              <a:off x="6932520" y="5573880"/>
              <a:ext cx="42480" cy="212400"/>
            </a:xfrm>
            <a:custGeom>
              <a:avLst/>
              <a:gdLst>
                <a:gd name="textAreaLeft" fmla="*/ 0 w 42480"/>
                <a:gd name="textAreaRight" fmla="*/ 42840 w 42480"/>
                <a:gd name="textAreaTop" fmla="*/ 0 h 212400"/>
                <a:gd name="textAreaBottom" fmla="*/ 212760 h 212400"/>
              </a:gdLst>
              <a:ahLst/>
              <a:rect l="textAreaLeft" t="textAreaTop" r="textAreaRight" b="textAreaBottom"/>
              <a:pathLst>
                <a:path w="3607" h="10475">
                  <a:moveTo>
                    <a:pt x="3607" y="10475"/>
                  </a:moveTo>
                  <a:cubicBezTo>
                    <a:pt x="1937" y="10475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475"/>
                    <a:pt x="2782" y="10475"/>
                  </a:cubicBezTo>
                  <a:lnTo>
                    <a:pt x="3607" y="10475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0" name="Freeform 11"/>
            <p:cNvSpPr/>
            <p:nvPr/>
          </p:nvSpPr>
          <p:spPr>
            <a:xfrm>
              <a:off x="6998040" y="5573880"/>
              <a:ext cx="42480" cy="210960"/>
            </a:xfrm>
            <a:custGeom>
              <a:avLst/>
              <a:gdLst>
                <a:gd name="textAreaLeft" fmla="*/ 0 w 42480"/>
                <a:gd name="textAreaRight" fmla="*/ 42840 w 42480"/>
                <a:gd name="textAreaTop" fmla="*/ 0 h 210960"/>
                <a:gd name="textAreaBottom" fmla="*/ 211320 h 210960"/>
              </a:gdLst>
              <a:ahLst/>
              <a:rect l="textAreaLeft" t="textAreaTop" r="textAreaRight" b="textAreaBottom"/>
              <a:pathLst>
                <a:path w="3607" h="10475">
                  <a:moveTo>
                    <a:pt x="3607" y="10475"/>
                  </a:moveTo>
                  <a:cubicBezTo>
                    <a:pt x="1937" y="10475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475"/>
                    <a:pt x="2782" y="10475"/>
                  </a:cubicBezTo>
                  <a:lnTo>
                    <a:pt x="3607" y="10475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1" name="Freeform 8"/>
            <p:cNvSpPr/>
            <p:nvPr/>
          </p:nvSpPr>
          <p:spPr>
            <a:xfrm>
              <a:off x="6899400" y="5573880"/>
              <a:ext cx="42480" cy="212400"/>
            </a:xfrm>
            <a:custGeom>
              <a:avLst/>
              <a:gdLst>
                <a:gd name="textAreaLeft" fmla="*/ 0 w 42480"/>
                <a:gd name="textAreaRight" fmla="*/ 42840 w 42480"/>
                <a:gd name="textAreaTop" fmla="*/ 0 h 212400"/>
                <a:gd name="textAreaBottom" fmla="*/ 212760 h 212400"/>
              </a:gdLst>
              <a:ahLst/>
              <a:rect l="textAreaLeft" t="textAreaTop" r="textAreaRight" b="textAreaBottom"/>
              <a:pathLst>
                <a:path w="3607" h="10500">
                  <a:moveTo>
                    <a:pt x="3607" y="10500"/>
                  </a:moveTo>
                  <a:cubicBezTo>
                    <a:pt x="1937" y="10500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500"/>
                    <a:pt x="2782" y="10500"/>
                  </a:cubicBezTo>
                  <a:lnTo>
                    <a:pt x="3607" y="1050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2" name="Freeform 12"/>
            <p:cNvSpPr/>
            <p:nvPr/>
          </p:nvSpPr>
          <p:spPr>
            <a:xfrm>
              <a:off x="6964920" y="5573880"/>
              <a:ext cx="42480" cy="212400"/>
            </a:xfrm>
            <a:custGeom>
              <a:avLst/>
              <a:gdLst>
                <a:gd name="textAreaLeft" fmla="*/ 0 w 42480"/>
                <a:gd name="textAreaRight" fmla="*/ 42840 w 42480"/>
                <a:gd name="textAreaTop" fmla="*/ 0 h 212400"/>
                <a:gd name="textAreaBottom" fmla="*/ 212760 h 212400"/>
              </a:gdLst>
              <a:ahLst/>
              <a:rect l="textAreaLeft" t="textAreaTop" r="textAreaRight" b="textAreaBottom"/>
              <a:pathLst>
                <a:path w="3607" h="10500">
                  <a:moveTo>
                    <a:pt x="3607" y="10500"/>
                  </a:moveTo>
                  <a:cubicBezTo>
                    <a:pt x="1937" y="10500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500"/>
                    <a:pt x="2782" y="10500"/>
                  </a:cubicBezTo>
                  <a:lnTo>
                    <a:pt x="3607" y="1050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33" name="Textfeld 18447"/>
          <p:cNvSpPr/>
          <p:nvPr/>
        </p:nvSpPr>
        <p:spPr>
          <a:xfrm>
            <a:off x="4334040" y="3444840"/>
            <a:ext cx="1434960" cy="1191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       </a:t>
            </a:r>
            <a:r>
              <a:rPr b="1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IR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      </a:t>
            </a:r>
            <a:r>
              <a:rPr b="1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PI3K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      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       </a:t>
            </a:r>
            <a:r>
              <a:rPr b="1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Akt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4" name="Textfeld 18448"/>
          <p:cNvSpPr/>
          <p:nvPr/>
        </p:nvSpPr>
        <p:spPr>
          <a:xfrm>
            <a:off x="1749600" y="3111480"/>
            <a:ext cx="3327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US" sz="1600" spc="-1" strike="noStrike">
                <a:solidFill>
                  <a:srgbClr val="ff0000"/>
                </a:solidFill>
                <a:latin typeface="Arial"/>
                <a:ea typeface="Arial"/>
              </a:rPr>
              <a:t>LAT 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      </a:t>
            </a:r>
            <a:r>
              <a:rPr b="0" lang="en-US" sz="1600" spc="-1" strike="noStrike">
                <a:solidFill>
                  <a:srgbClr val="ff0000"/>
                </a:solidFill>
                <a:latin typeface="Arial"/>
                <a:ea typeface="Arial"/>
              </a:rPr>
              <a:t>TNFR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5" name="Textfeld 18449"/>
          <p:cNvSpPr/>
          <p:nvPr/>
        </p:nvSpPr>
        <p:spPr>
          <a:xfrm>
            <a:off x="3166920" y="3114720"/>
            <a:ext cx="45500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     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VDR         </a:t>
            </a:r>
            <a:r>
              <a:rPr b="0" lang="en-US" sz="1600" spc="-1" strike="noStrike">
                <a:solidFill>
                  <a:srgbClr val="ff0000"/>
                </a:solidFill>
                <a:latin typeface="Arial"/>
                <a:ea typeface="Arial"/>
              </a:rPr>
              <a:t>IGF1R    IR   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  <a:ea typeface="Arial"/>
              </a:rPr>
              <a:t>                    AR*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6" name="Oval 18451"/>
          <p:cNvSpPr/>
          <p:nvPr/>
        </p:nvSpPr>
        <p:spPr>
          <a:xfrm>
            <a:off x="5670720" y="5164200"/>
            <a:ext cx="880920" cy="423720"/>
          </a:xfrm>
          <a:prstGeom prst="ellipse">
            <a:avLst/>
          </a:prstGeom>
          <a:blipFill rotWithShape="0">
            <a:blip r:embed="rId2"/>
            <a:srcRect/>
            <a:tile tx="0" ty="0" sx="100000" sy="100000" algn="ctr"/>
          </a:blipFill>
          <a:ln w="9360">
            <a:solidFill>
              <a:srgbClr val="4a7ebb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7" name="Oval 199"/>
          <p:cNvSpPr/>
          <p:nvPr/>
        </p:nvSpPr>
        <p:spPr>
          <a:xfrm>
            <a:off x="6892920" y="4497480"/>
            <a:ext cx="841320" cy="425520"/>
          </a:xfrm>
          <a:prstGeom prst="ellipse">
            <a:avLst/>
          </a:prstGeom>
          <a:blipFill rotWithShape="0">
            <a:blip r:embed="rId3"/>
            <a:srcRect/>
            <a:tile tx="0" ty="0" sx="100000" sy="100000" algn="ctr"/>
          </a:blipFill>
          <a:ln w="9360">
            <a:solidFill>
              <a:srgbClr val="4a7ebb"/>
            </a:solidFill>
            <a:miter/>
          </a:ln>
          <a:effectLst>
            <a:outerShdw dist="23040" dir="5400000" blurRad="0" rotWithShape="0">
              <a:srgbClr val="808080">
                <a:alpha val="27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8" name="Textfeld 18452"/>
          <p:cNvSpPr/>
          <p:nvPr/>
        </p:nvSpPr>
        <p:spPr>
          <a:xfrm>
            <a:off x="5648400" y="5162400"/>
            <a:ext cx="920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FoxO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9" name="Sechseck 18454"/>
          <p:cNvSpPr/>
          <p:nvPr/>
        </p:nvSpPr>
        <p:spPr>
          <a:xfrm>
            <a:off x="6273720" y="4983120"/>
            <a:ext cx="268200" cy="249120"/>
          </a:xfrm>
          <a:prstGeom prst="hexagon">
            <a:avLst>
              <a:gd name="adj" fmla="val 25006"/>
              <a:gd name="vf" fmla="val 115470"/>
            </a:avLst>
          </a:prstGeom>
          <a:solidFill>
            <a:srgbClr val="ff0000"/>
          </a:solidFill>
          <a:ln w="0">
            <a:noFill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0" name="Sechseck 203"/>
          <p:cNvSpPr/>
          <p:nvPr/>
        </p:nvSpPr>
        <p:spPr>
          <a:xfrm>
            <a:off x="7466040" y="4299120"/>
            <a:ext cx="268200" cy="249120"/>
          </a:xfrm>
          <a:prstGeom prst="hexagon">
            <a:avLst>
              <a:gd name="adj" fmla="val 25006"/>
              <a:gd name="vf" fmla="val 115470"/>
            </a:avLst>
          </a:prstGeom>
          <a:solidFill>
            <a:srgbClr val="ff0000"/>
          </a:solidFill>
          <a:ln w="0">
            <a:noFill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141" name="Gerade Verbindung mit Pfeil 204"/>
          <p:cNvCxnSpPr/>
          <p:nvPr/>
        </p:nvCxnSpPr>
        <p:spPr>
          <a:xfrm flipV="1">
            <a:off x="6585120" y="4836600"/>
            <a:ext cx="614880" cy="396000"/>
          </a:xfrm>
          <a:prstGeom prst="straightConnector1">
            <a:avLst/>
          </a:prstGeom>
          <a:ln w="38160">
            <a:solidFill>
              <a:srgbClr val="ff0000"/>
            </a:solidFill>
            <a:miter/>
            <a:tailEnd len="med" type="triangle" w="med"/>
          </a:ln>
        </p:spPr>
      </p:cxnSp>
      <p:sp>
        <p:nvSpPr>
          <p:cNvPr id="142" name="Textfeld 18458"/>
          <p:cNvSpPr/>
          <p:nvPr/>
        </p:nvSpPr>
        <p:spPr>
          <a:xfrm>
            <a:off x="6259680" y="4941720"/>
            <a:ext cx="241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ffffff"/>
                </a:solidFill>
                <a:latin typeface="Arial"/>
                <a:ea typeface="Arial"/>
              </a:rPr>
              <a:t>P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3" name="Textfeld 209"/>
          <p:cNvSpPr/>
          <p:nvPr/>
        </p:nvSpPr>
        <p:spPr>
          <a:xfrm>
            <a:off x="7466040" y="4257720"/>
            <a:ext cx="2430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ffffff"/>
                </a:solidFill>
                <a:latin typeface="Arial"/>
                <a:ea typeface="Arial"/>
              </a:rPr>
              <a:t>P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4" name="Textfeld 18459"/>
          <p:cNvSpPr/>
          <p:nvPr/>
        </p:nvSpPr>
        <p:spPr>
          <a:xfrm>
            <a:off x="6923160" y="4503600"/>
            <a:ext cx="890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FoxO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5" name="Textfeld 18462"/>
          <p:cNvSpPr/>
          <p:nvPr/>
        </p:nvSpPr>
        <p:spPr>
          <a:xfrm>
            <a:off x="2801880" y="4578480"/>
            <a:ext cx="1532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TSC1/TSC2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6" name="Textfeld 65"/>
          <p:cNvSpPr/>
          <p:nvPr/>
        </p:nvSpPr>
        <p:spPr>
          <a:xfrm>
            <a:off x="3159000" y="5151600"/>
            <a:ext cx="830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Rhe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7" name="Textfeld 70"/>
          <p:cNvSpPr/>
          <p:nvPr/>
        </p:nvSpPr>
        <p:spPr>
          <a:xfrm>
            <a:off x="2711520" y="5629320"/>
            <a:ext cx="1744560" cy="398880"/>
          </a:xfrm>
          <a:prstGeom prst="rect">
            <a:avLst/>
          </a:prstGeom>
          <a:solidFill>
            <a:srgbClr val="ffff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000" spc="-1" strike="noStrike">
                <a:solidFill>
                  <a:srgbClr val="ff0000"/>
                </a:solidFill>
                <a:latin typeface="Arial"/>
                <a:ea typeface="Arial"/>
              </a:rPr>
              <a:t>mTORC1 </a:t>
            </a:r>
            <a:r>
              <a:rPr b="1" lang="en-US" sz="2000" spc="-1" strike="noStrike">
                <a:solidFill>
                  <a:srgbClr val="ff0000"/>
                </a:solidFill>
                <a:latin typeface="Wingdings"/>
                <a:ea typeface="Wingdings"/>
              </a:rPr>
              <a:t>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8" name="Textfeld 71"/>
          <p:cNvSpPr/>
          <p:nvPr/>
        </p:nvSpPr>
        <p:spPr>
          <a:xfrm>
            <a:off x="1503360" y="5137200"/>
            <a:ext cx="1298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  </a:t>
            </a:r>
            <a:r>
              <a:rPr b="1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Leucin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149" name="Gerade Verbindung mit Pfeil 221"/>
          <p:cNvCxnSpPr/>
          <p:nvPr/>
        </p:nvCxnSpPr>
        <p:spPr>
          <a:xfrm>
            <a:off x="2053800" y="3471840"/>
            <a:ext cx="1080" cy="1704240"/>
          </a:xfrm>
          <a:prstGeom prst="straightConnector1">
            <a:avLst/>
          </a:prstGeom>
          <a:ln w="38160">
            <a:solidFill>
              <a:srgbClr val="ff0000"/>
            </a:solidFill>
            <a:miter/>
            <a:tailEnd len="med" type="triangle" w="med"/>
          </a:ln>
        </p:spPr>
      </p:cxnSp>
      <p:cxnSp>
        <p:nvCxnSpPr>
          <p:cNvPr id="150" name="Gerade Verbindung mit Pfeil 223"/>
          <p:cNvCxnSpPr/>
          <p:nvPr/>
        </p:nvCxnSpPr>
        <p:spPr>
          <a:xfrm>
            <a:off x="2711160" y="5360760"/>
            <a:ext cx="506880" cy="1080"/>
          </a:xfrm>
          <a:prstGeom prst="straightConnector1">
            <a:avLst/>
          </a:prstGeom>
          <a:ln w="38160">
            <a:solidFill>
              <a:srgbClr val="ff0000"/>
            </a:solidFill>
            <a:miter/>
            <a:tailEnd len="med" type="triangle" w="med"/>
          </a:ln>
        </p:spPr>
      </p:cxnSp>
      <p:cxnSp>
        <p:nvCxnSpPr>
          <p:cNvPr id="151" name="Gerade Verbindung mit Pfeil 227"/>
          <p:cNvCxnSpPr/>
          <p:nvPr/>
        </p:nvCxnSpPr>
        <p:spPr>
          <a:xfrm flipH="1">
            <a:off x="4205160" y="4578120"/>
            <a:ext cx="603720" cy="184680"/>
          </a:xfrm>
          <a:prstGeom prst="straightConnector1">
            <a:avLst/>
          </a:prstGeom>
          <a:ln w="38160">
            <a:solidFill>
              <a:srgbClr val="ff0000"/>
            </a:solidFill>
            <a:miter/>
          </a:ln>
        </p:spPr>
      </p:cxnSp>
      <p:cxnSp>
        <p:nvCxnSpPr>
          <p:cNvPr id="152" name="Gerade Verbindung mit Pfeil 229"/>
          <p:cNvCxnSpPr/>
          <p:nvPr/>
        </p:nvCxnSpPr>
        <p:spPr>
          <a:xfrm flipV="1">
            <a:off x="4204800" y="4656960"/>
            <a:ext cx="1080" cy="214920"/>
          </a:xfrm>
          <a:prstGeom prst="straightConnector1">
            <a:avLst/>
          </a:prstGeom>
          <a:ln w="38160">
            <a:solidFill>
              <a:srgbClr val="ff0000"/>
            </a:solidFill>
            <a:miter/>
          </a:ln>
        </p:spPr>
      </p:cxnSp>
      <p:cxnSp>
        <p:nvCxnSpPr>
          <p:cNvPr id="153" name="Gerade Verbindung mit Pfeil 249"/>
          <p:cNvCxnSpPr/>
          <p:nvPr/>
        </p:nvCxnSpPr>
        <p:spPr>
          <a:xfrm flipH="1">
            <a:off x="3447720" y="5168520"/>
            <a:ext cx="216720" cy="1080"/>
          </a:xfrm>
          <a:prstGeom prst="straightConnector1">
            <a:avLst/>
          </a:prstGeom>
          <a:ln w="19080">
            <a:solidFill>
              <a:srgbClr val="000000"/>
            </a:solidFill>
            <a:miter/>
          </a:ln>
        </p:spPr>
      </p:cxnSp>
      <p:cxnSp>
        <p:nvCxnSpPr>
          <p:cNvPr id="154" name="Gerade Verbindung mit Pfeil 250"/>
          <p:cNvCxnSpPr/>
          <p:nvPr/>
        </p:nvCxnSpPr>
        <p:spPr>
          <a:xfrm flipV="1">
            <a:off x="3536640" y="4893480"/>
            <a:ext cx="1080" cy="281880"/>
          </a:xfrm>
          <a:prstGeom prst="straightConnector1">
            <a:avLst/>
          </a:prstGeom>
          <a:ln w="19080">
            <a:solidFill>
              <a:srgbClr val="000000"/>
            </a:solidFill>
            <a:miter/>
          </a:ln>
        </p:spPr>
      </p:cxnSp>
      <p:sp>
        <p:nvSpPr>
          <p:cNvPr id="155" name="Textfeld 253"/>
          <p:cNvSpPr/>
          <p:nvPr/>
        </p:nvSpPr>
        <p:spPr>
          <a:xfrm>
            <a:off x="1017720" y="4362480"/>
            <a:ext cx="1311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Ragulator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6" name="Pfeil nach unten 254"/>
          <p:cNvSpPr/>
          <p:nvPr/>
        </p:nvSpPr>
        <p:spPr>
          <a:xfrm>
            <a:off x="3430440" y="5473800"/>
            <a:ext cx="214560" cy="230040"/>
          </a:xfrm>
          <a:prstGeom prst="downArrow">
            <a:avLst>
              <a:gd name="adj1" fmla="val 50000"/>
              <a:gd name="adj2" fmla="val 49909"/>
            </a:avLst>
          </a:prstGeom>
          <a:solidFill>
            <a:srgbClr val="ff0000"/>
          </a:solidFill>
          <a:ln w="9360">
            <a:solidFill>
              <a:srgbClr val="ff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157" name="Gerade Verbindung mit Pfeil 268"/>
          <p:cNvCxnSpPr/>
          <p:nvPr/>
        </p:nvCxnSpPr>
        <p:spPr>
          <a:xfrm>
            <a:off x="5373720" y="4578480"/>
            <a:ext cx="591120" cy="514440"/>
          </a:xfrm>
          <a:prstGeom prst="straightConnector1">
            <a:avLst/>
          </a:prstGeom>
          <a:ln w="38160">
            <a:solidFill>
              <a:srgbClr val="ff0000"/>
            </a:solidFill>
            <a:miter/>
          </a:ln>
        </p:spPr>
      </p:cxnSp>
      <p:cxnSp>
        <p:nvCxnSpPr>
          <p:cNvPr id="158" name="Gerade Verbindung mit Pfeil 284"/>
          <p:cNvCxnSpPr/>
          <p:nvPr/>
        </p:nvCxnSpPr>
        <p:spPr>
          <a:xfrm flipH="1">
            <a:off x="3522240" y="5968800"/>
            <a:ext cx="15120" cy="376920"/>
          </a:xfrm>
          <a:prstGeom prst="straightConnector1">
            <a:avLst/>
          </a:prstGeom>
          <a:ln w="381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59" name="Gerade Verbindung mit Pfeil 286"/>
          <p:cNvCxnSpPr/>
          <p:nvPr/>
        </p:nvCxnSpPr>
        <p:spPr>
          <a:xfrm>
            <a:off x="3555720" y="6021360"/>
            <a:ext cx="524160" cy="324720"/>
          </a:xfrm>
          <a:prstGeom prst="straightConnector1">
            <a:avLst/>
          </a:prstGeom>
          <a:ln w="381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60" name="Gerade Verbindung mit Pfeil 290"/>
          <p:cNvCxnSpPr/>
          <p:nvPr/>
        </p:nvCxnSpPr>
        <p:spPr>
          <a:xfrm flipH="1">
            <a:off x="3055680" y="6012000"/>
            <a:ext cx="467280" cy="257760"/>
          </a:xfrm>
          <a:prstGeom prst="straightConnector1">
            <a:avLst/>
          </a:prstGeom>
          <a:ln w="38160">
            <a:solidFill>
              <a:srgbClr val="000000"/>
            </a:solidFill>
            <a:miter/>
          </a:ln>
        </p:spPr>
      </p:cxnSp>
      <p:cxnSp>
        <p:nvCxnSpPr>
          <p:cNvPr id="161" name="Gerade Verbindung mit Pfeil 293"/>
          <p:cNvCxnSpPr/>
          <p:nvPr/>
        </p:nvCxnSpPr>
        <p:spPr>
          <a:xfrm>
            <a:off x="2950920" y="6192720"/>
            <a:ext cx="168840" cy="153360"/>
          </a:xfrm>
          <a:prstGeom prst="straightConnector1">
            <a:avLst/>
          </a:prstGeom>
          <a:ln w="38160">
            <a:solidFill>
              <a:srgbClr val="000000"/>
            </a:solidFill>
            <a:miter/>
          </a:ln>
        </p:spPr>
      </p:cxnSp>
      <p:sp>
        <p:nvSpPr>
          <p:cNvPr id="162" name="Textfeld 18487"/>
          <p:cNvSpPr/>
          <p:nvPr/>
        </p:nvSpPr>
        <p:spPr>
          <a:xfrm>
            <a:off x="2054160" y="6345360"/>
            <a:ext cx="3062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4E-BP-1   Lipin1    S6K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163" name="Gerade Verbindung mit Pfeil 304"/>
          <p:cNvCxnSpPr/>
          <p:nvPr/>
        </p:nvCxnSpPr>
        <p:spPr>
          <a:xfrm flipV="1">
            <a:off x="5850000" y="4982400"/>
            <a:ext cx="240480" cy="214920"/>
          </a:xfrm>
          <a:prstGeom prst="straightConnector1">
            <a:avLst/>
          </a:prstGeom>
          <a:ln w="38160">
            <a:solidFill>
              <a:srgbClr val="ff0000"/>
            </a:solidFill>
            <a:miter/>
          </a:ln>
        </p:spPr>
      </p:cxnSp>
      <p:sp>
        <p:nvSpPr>
          <p:cNvPr id="164" name="Nach oben gebogener Pfeil 328"/>
          <p:cNvSpPr/>
          <p:nvPr/>
        </p:nvSpPr>
        <p:spPr>
          <a:xfrm flipH="1" flipV="1" rot="16200000">
            <a:off x="6253200" y="5629320"/>
            <a:ext cx="412560" cy="768240"/>
          </a:xfrm>
          <a:custGeom>
            <a:avLst/>
            <a:gdLst/>
            <a:ahLst/>
            <a:rect l="l" t="t" r="r" b="b"/>
            <a:pathLst>
              <a:path w="412750" h="768350">
                <a:moveTo>
                  <a:pt x="0" y="724859"/>
                </a:moveTo>
                <a:lnTo>
                  <a:pt x="287817" y="724859"/>
                </a:lnTo>
                <a:lnTo>
                  <a:pt x="287817" y="103188"/>
                </a:lnTo>
                <a:lnTo>
                  <a:pt x="206375" y="103188"/>
                </a:lnTo>
                <a:lnTo>
                  <a:pt x="309563" y="0"/>
                </a:lnTo>
                <a:lnTo>
                  <a:pt x="412750" y="103188"/>
                </a:lnTo>
                <a:lnTo>
                  <a:pt x="331308" y="103188"/>
                </a:lnTo>
                <a:lnTo>
                  <a:pt x="331308" y="768350"/>
                </a:lnTo>
                <a:lnTo>
                  <a:pt x="0" y="768350"/>
                </a:lnTo>
                <a:lnTo>
                  <a:pt x="0" y="724859"/>
                </a:lnTo>
                <a:close/>
              </a:path>
            </a:pathLst>
          </a:custGeom>
          <a:gradFill rotWithShape="0">
            <a:gsLst>
              <a:gs pos="0">
                <a:srgbClr val="9bc1ff"/>
              </a:gs>
              <a:gs pos="100000">
                <a:srgbClr val="3f80cd"/>
              </a:gs>
            </a:gsLst>
            <a:lin ang="10800000"/>
          </a:gradFill>
          <a:ln w="9360">
            <a:solidFill>
              <a:srgbClr val="7f7f7f"/>
            </a:solidFill>
            <a:round/>
          </a:ln>
          <a:effectLst>
            <a:outerShdw dist="23040" dir="5400000" blurRad="0" rotWithShape="0">
              <a:srgbClr val="00000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5" name="Textfeld 272"/>
          <p:cNvSpPr/>
          <p:nvPr/>
        </p:nvSpPr>
        <p:spPr>
          <a:xfrm>
            <a:off x="5392800" y="6143760"/>
            <a:ext cx="288108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Suppressed FoxO1-mediated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gene expression (p21, p27)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6" name="Textfeld 273"/>
          <p:cNvSpPr/>
          <p:nvPr/>
        </p:nvSpPr>
        <p:spPr>
          <a:xfrm>
            <a:off x="7918560" y="244440"/>
            <a:ext cx="982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Fig. 1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7" name="Textfeld 10"/>
          <p:cNvSpPr/>
          <p:nvPr/>
        </p:nvSpPr>
        <p:spPr>
          <a:xfrm>
            <a:off x="5892840" y="4351320"/>
            <a:ext cx="885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  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VitD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8" name="Textfeld 14"/>
          <p:cNvSpPr/>
          <p:nvPr/>
        </p:nvSpPr>
        <p:spPr>
          <a:xfrm>
            <a:off x="1503360" y="2655720"/>
            <a:ext cx="6426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1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Leucine  TNFα*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   VitD </a:t>
            </a:r>
            <a:r>
              <a:rPr b="1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  </a:t>
            </a:r>
            <a:r>
              <a:rPr b="1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IGF-1*  Insulin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          </a:t>
            </a:r>
            <a:r>
              <a:rPr b="1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Androgen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9" name="Textfeld 20"/>
          <p:cNvSpPr/>
          <p:nvPr/>
        </p:nvSpPr>
        <p:spPr>
          <a:xfrm>
            <a:off x="2532240" y="3889440"/>
            <a:ext cx="2128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1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IKKβ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    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DDIT4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0" name="Textfeld 22"/>
          <p:cNvSpPr/>
          <p:nvPr/>
        </p:nvSpPr>
        <p:spPr>
          <a:xfrm>
            <a:off x="5997600" y="3833640"/>
            <a:ext cx="17272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000" spc="-1" strike="noStrike">
                <a:solidFill>
                  <a:srgbClr val="ff0000"/>
                </a:solidFill>
                <a:latin typeface="Arial"/>
                <a:ea typeface="Arial"/>
              </a:rPr>
              <a:t>   </a:t>
            </a:r>
            <a:r>
              <a:rPr b="1" lang="en-US" sz="2000" spc="-1" strike="noStrike">
                <a:solidFill>
                  <a:srgbClr val="ff0000"/>
                </a:solidFill>
                <a:latin typeface="Arial"/>
                <a:ea typeface="Arial"/>
              </a:rPr>
              <a:t>mTORC2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171" name="Gerade Verbindung mit Pfeil 200"/>
          <p:cNvCxnSpPr/>
          <p:nvPr/>
        </p:nvCxnSpPr>
        <p:spPr>
          <a:xfrm flipH="1">
            <a:off x="5346360" y="4186080"/>
            <a:ext cx="870480" cy="262800"/>
          </a:xfrm>
          <a:prstGeom prst="straightConnector1">
            <a:avLst/>
          </a:prstGeom>
          <a:ln w="38160">
            <a:solidFill>
              <a:srgbClr val="ff0000"/>
            </a:solidFill>
            <a:miter/>
            <a:tailEnd len="med" type="triangle" w="med"/>
          </a:ln>
        </p:spPr>
      </p:cxnSp>
      <p:cxnSp>
        <p:nvCxnSpPr>
          <p:cNvPr id="172" name="Gerade Verbindung mit Pfeil 205"/>
          <p:cNvCxnSpPr/>
          <p:nvPr/>
        </p:nvCxnSpPr>
        <p:spPr>
          <a:xfrm flipH="1">
            <a:off x="6942960" y="3475080"/>
            <a:ext cx="1080" cy="388080"/>
          </a:xfrm>
          <a:prstGeom prst="straightConnector1">
            <a:avLst/>
          </a:prstGeom>
          <a:ln w="38160">
            <a:solidFill>
              <a:srgbClr val="ff0000"/>
            </a:solidFill>
            <a:miter/>
            <a:tailEnd len="med" type="triangle" w="med"/>
          </a:ln>
        </p:spPr>
      </p:cxnSp>
      <p:cxnSp>
        <p:nvCxnSpPr>
          <p:cNvPr id="173" name="Gerade Verbindung mit Pfeil 209"/>
          <p:cNvCxnSpPr/>
          <p:nvPr/>
        </p:nvCxnSpPr>
        <p:spPr>
          <a:xfrm>
            <a:off x="5070240" y="4009680"/>
            <a:ext cx="1080" cy="353160"/>
          </a:xfrm>
          <a:prstGeom prst="straightConnector1">
            <a:avLst/>
          </a:prstGeom>
          <a:ln w="38160">
            <a:solidFill>
              <a:srgbClr val="ff0000"/>
            </a:solidFill>
            <a:miter/>
            <a:tailEnd len="med" type="triangle" w="med"/>
          </a:ln>
        </p:spPr>
      </p:cxnSp>
      <p:cxnSp>
        <p:nvCxnSpPr>
          <p:cNvPr id="174" name="Gerade Verbindung mit Pfeil 212"/>
          <p:cNvCxnSpPr>
            <a:endCxn id="145" idx="0"/>
          </p:cNvCxnSpPr>
          <p:nvPr/>
        </p:nvCxnSpPr>
        <p:spPr>
          <a:xfrm flipH="1">
            <a:off x="3567960" y="4246560"/>
            <a:ext cx="213480" cy="332280"/>
          </a:xfrm>
          <a:prstGeom prst="straightConnector1">
            <a:avLst/>
          </a:prstGeom>
          <a:ln w="381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75" name="Gerade Verbindung mit Pfeil 215"/>
          <p:cNvCxnSpPr/>
          <p:nvPr/>
        </p:nvCxnSpPr>
        <p:spPr>
          <a:xfrm>
            <a:off x="2949120" y="3444840"/>
            <a:ext cx="1080" cy="418320"/>
          </a:xfrm>
          <a:prstGeom prst="straightConnector1">
            <a:avLst/>
          </a:prstGeom>
          <a:ln w="38160">
            <a:solidFill>
              <a:srgbClr val="ff0000"/>
            </a:solidFill>
            <a:miter/>
            <a:tailEnd len="med" type="triangle" w="med"/>
          </a:ln>
        </p:spPr>
      </p:cxnSp>
      <p:cxnSp>
        <p:nvCxnSpPr>
          <p:cNvPr id="176" name="Gerade Verbindung mit Pfeil 218"/>
          <p:cNvCxnSpPr/>
          <p:nvPr/>
        </p:nvCxnSpPr>
        <p:spPr>
          <a:xfrm flipH="1" flipV="1">
            <a:off x="2950560" y="4211280"/>
            <a:ext cx="221400" cy="349920"/>
          </a:xfrm>
          <a:prstGeom prst="straightConnector1">
            <a:avLst/>
          </a:prstGeom>
          <a:ln w="38160">
            <a:solidFill>
              <a:srgbClr val="ff0000"/>
            </a:solidFill>
            <a:miter/>
          </a:ln>
        </p:spPr>
      </p:cxnSp>
      <p:cxnSp>
        <p:nvCxnSpPr>
          <p:cNvPr id="177" name="Gerade Verbindung mit Pfeil 219"/>
          <p:cNvCxnSpPr/>
          <p:nvPr/>
        </p:nvCxnSpPr>
        <p:spPr>
          <a:xfrm>
            <a:off x="3060720" y="4578120"/>
            <a:ext cx="226080" cy="1080"/>
          </a:xfrm>
          <a:prstGeom prst="straightConnector1">
            <a:avLst/>
          </a:prstGeom>
          <a:ln w="38160">
            <a:solidFill>
              <a:srgbClr val="ff0000"/>
            </a:solidFill>
            <a:miter/>
          </a:ln>
        </p:spPr>
      </p:cxnSp>
      <p:cxnSp>
        <p:nvCxnSpPr>
          <p:cNvPr id="178" name="Gerade Verbindung mit Pfeil 228"/>
          <p:cNvCxnSpPr/>
          <p:nvPr/>
        </p:nvCxnSpPr>
        <p:spPr>
          <a:xfrm flipH="1">
            <a:off x="3780720" y="3444840"/>
            <a:ext cx="1080" cy="426240"/>
          </a:xfrm>
          <a:prstGeom prst="straightConnector1">
            <a:avLst/>
          </a:prstGeom>
          <a:ln w="381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79" name="Gerade Verbindung mit Pfeil 230"/>
          <p:cNvCxnSpPr/>
          <p:nvPr/>
        </p:nvCxnSpPr>
        <p:spPr>
          <a:xfrm>
            <a:off x="6478200" y="4684320"/>
            <a:ext cx="204120" cy="299160"/>
          </a:xfrm>
          <a:prstGeom prst="straightConnector1">
            <a:avLst/>
          </a:prstGeom>
          <a:ln w="38160">
            <a:solidFill>
              <a:srgbClr val="000000"/>
            </a:solidFill>
            <a:miter/>
          </a:ln>
        </p:spPr>
      </p:cxnSp>
      <p:cxnSp>
        <p:nvCxnSpPr>
          <p:cNvPr id="180" name="Gerade Verbindung mit Pfeil 232"/>
          <p:cNvCxnSpPr/>
          <p:nvPr/>
        </p:nvCxnSpPr>
        <p:spPr>
          <a:xfrm flipV="1">
            <a:off x="6595560" y="4947840"/>
            <a:ext cx="172440" cy="116640"/>
          </a:xfrm>
          <a:prstGeom prst="straightConnector1">
            <a:avLst/>
          </a:prstGeom>
          <a:ln w="38160">
            <a:solidFill>
              <a:srgbClr val="000000"/>
            </a:solidFill>
            <a:miter/>
          </a:ln>
        </p:spPr>
      </p:cxnSp>
      <p:sp>
        <p:nvSpPr>
          <p:cNvPr id="181" name="Rechteck 1"/>
          <p:cNvSpPr/>
          <p:nvPr/>
        </p:nvSpPr>
        <p:spPr>
          <a:xfrm>
            <a:off x="1158840" y="857160"/>
            <a:ext cx="7064280" cy="1003320"/>
          </a:xfrm>
          <a:prstGeom prst="rect">
            <a:avLst/>
          </a:prstGeom>
          <a:solidFill>
            <a:srgbClr val="fdeada"/>
          </a:solidFill>
          <a:ln w="9360">
            <a:solidFill>
              <a:srgbClr val="ff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2" name="Textfeld 2"/>
          <p:cNvSpPr/>
          <p:nvPr/>
        </p:nvSpPr>
        <p:spPr>
          <a:xfrm>
            <a:off x="1228680" y="890640"/>
            <a:ext cx="699444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                                    </a:t>
            </a:r>
            <a:r>
              <a:rPr b="1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W E S T E R N   D I E T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Animal protein            High glycaemic load      Commercial milk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Dairy protein                   Excess sucrose          androgen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183" name="Gerade Verbindung mit Pfeil 158"/>
          <p:cNvCxnSpPr/>
          <p:nvPr/>
        </p:nvCxnSpPr>
        <p:spPr>
          <a:xfrm flipH="1">
            <a:off x="6938280" y="1860480"/>
            <a:ext cx="1080" cy="853200"/>
          </a:xfrm>
          <a:prstGeom prst="straightConnector1">
            <a:avLst/>
          </a:prstGeom>
          <a:ln w="38160">
            <a:solidFill>
              <a:srgbClr val="ff0000"/>
            </a:solidFill>
            <a:miter/>
            <a:tailEnd len="med" type="triangle" w="med"/>
          </a:ln>
        </p:spPr>
      </p:cxnSp>
      <p:cxnSp>
        <p:nvCxnSpPr>
          <p:cNvPr id="184" name="Gerade Verbindung mit Pfeil 162"/>
          <p:cNvCxnSpPr/>
          <p:nvPr/>
        </p:nvCxnSpPr>
        <p:spPr>
          <a:xfrm>
            <a:off x="5346360" y="1860120"/>
            <a:ext cx="1080" cy="795960"/>
          </a:xfrm>
          <a:prstGeom prst="straightConnector1">
            <a:avLst/>
          </a:prstGeom>
          <a:ln w="38160">
            <a:solidFill>
              <a:srgbClr val="ff0000"/>
            </a:solidFill>
            <a:miter/>
            <a:tailEnd len="med" type="triangle" w="med"/>
          </a:ln>
        </p:spPr>
      </p:cxnSp>
      <p:cxnSp>
        <p:nvCxnSpPr>
          <p:cNvPr id="185" name="Gerade Verbindung mit Pfeil 163"/>
          <p:cNvCxnSpPr/>
          <p:nvPr/>
        </p:nvCxnSpPr>
        <p:spPr>
          <a:xfrm flipH="1">
            <a:off x="2053440" y="1860480"/>
            <a:ext cx="1080" cy="853200"/>
          </a:xfrm>
          <a:prstGeom prst="straightConnector1">
            <a:avLst/>
          </a:prstGeom>
          <a:ln w="38160">
            <a:solidFill>
              <a:srgbClr val="ff0000"/>
            </a:solidFill>
            <a:miter/>
            <a:tailEnd len="med" type="triangle" w="med"/>
          </a:ln>
        </p:spPr>
      </p:cxnSp>
      <p:cxnSp>
        <p:nvCxnSpPr>
          <p:cNvPr id="186" name="Gerade Verbindung mit Pfeil 164"/>
          <p:cNvCxnSpPr/>
          <p:nvPr/>
        </p:nvCxnSpPr>
        <p:spPr>
          <a:xfrm>
            <a:off x="2531880" y="1860120"/>
            <a:ext cx="1802520" cy="795960"/>
          </a:xfrm>
          <a:prstGeom prst="straightConnector1">
            <a:avLst/>
          </a:prstGeom>
          <a:ln w="38160">
            <a:solidFill>
              <a:srgbClr val="ff0000"/>
            </a:solidFill>
            <a:miter/>
            <a:tailEnd len="med" type="triangle" w="med"/>
          </a:ln>
        </p:spPr>
      </p:cxnSp>
      <p:cxnSp>
        <p:nvCxnSpPr>
          <p:cNvPr id="187" name="Gerade Verbindung mit Pfeil 181"/>
          <p:cNvCxnSpPr/>
          <p:nvPr/>
        </p:nvCxnSpPr>
        <p:spPr>
          <a:xfrm>
            <a:off x="5987520" y="5889240"/>
            <a:ext cx="226440" cy="1080"/>
          </a:xfrm>
          <a:prstGeom prst="straightConnector1">
            <a:avLst/>
          </a:prstGeom>
          <a:ln w="38160">
            <a:solidFill>
              <a:srgbClr val="ff0000"/>
            </a:solidFill>
            <a:miter/>
          </a:ln>
        </p:spPr>
      </p:cxn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11-29T19:48:44Z</dcterms:created>
  <dc:creator>Bodo Melnik</dc:creator>
  <dc:description/>
  <dc:language>en-US</dc:language>
  <cp:lastModifiedBy>Bodo Melnik</cp:lastModifiedBy>
  <dcterms:modified xsi:type="dcterms:W3CDTF">2013-02-24T15:58:44Z</dcterms:modified>
  <cp:revision>22</cp:revision>
  <dc:subject/>
  <dc:title>PowerPoint-Präsentation</dc:title>
</cp:coreProperties>
</file>